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1"/>
  </p:notesMasterIdLst>
  <p:sldIdLst>
    <p:sldId id="256" r:id="rId2"/>
    <p:sldId id="257" r:id="rId3"/>
    <p:sldId id="259" r:id="rId4"/>
    <p:sldId id="260" r:id="rId5"/>
    <p:sldId id="264" r:id="rId6"/>
    <p:sldId id="267" r:id="rId7"/>
    <p:sldId id="268" r:id="rId8"/>
    <p:sldId id="274" r:id="rId9"/>
    <p:sldId id="275" r:id="rId10"/>
    <p:sldId id="276" r:id="rId11"/>
    <p:sldId id="278" r:id="rId12"/>
    <p:sldId id="279" r:id="rId13"/>
    <p:sldId id="281" r:id="rId14"/>
    <p:sldId id="282" r:id="rId15"/>
    <p:sldId id="284" r:id="rId16"/>
    <p:sldId id="285" r:id="rId17"/>
    <p:sldId id="286" r:id="rId18"/>
    <p:sldId id="288" r:id="rId19"/>
    <p:sldId id="289" r:id="rId20"/>
    <p:sldId id="290" r:id="rId21"/>
    <p:sldId id="293" r:id="rId22"/>
    <p:sldId id="294" r:id="rId23"/>
    <p:sldId id="296" r:id="rId24"/>
    <p:sldId id="297" r:id="rId25"/>
    <p:sldId id="300" r:id="rId26"/>
    <p:sldId id="301" r:id="rId27"/>
    <p:sldId id="304" r:id="rId28"/>
    <p:sldId id="305" r:id="rId29"/>
    <p:sldId id="308" r:id="rId30"/>
  </p:sldIdLst>
  <p:sldSz cx="12192000" cy="6858000"/>
  <p:notesSz cx="6858000" cy="9144000"/>
  <p:custDataLst>
    <p:tags r:id="rId32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D7279F8-4830-4E52-8D06-5EEC883E0D3F}" v="157" dt="2025-09-29T15:31:32.21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247" autoAdjust="0"/>
  </p:normalViewPr>
  <p:slideViewPr>
    <p:cSldViewPr snapToGrid="0">
      <p:cViewPr varScale="1">
        <p:scale>
          <a:sx n="161" d="100"/>
          <a:sy n="161" d="100"/>
        </p:scale>
        <p:origin x="308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38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ags" Target="tags/tag1.xml"/><Relationship Id="rId37" Type="http://schemas.microsoft.com/office/2016/11/relationships/changesInfo" Target="changesInfos/changesInfo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en Price" userId="64e0ee70-be78-4126-b6bb-b74f31a45510" providerId="ADAL" clId="{9D7279F8-4830-4E52-8D06-5EEC883E0D3F}"/>
    <pc:docChg chg="undo custSel addSld delSld modSld sldOrd">
      <pc:chgData name="Ben Price" userId="64e0ee70-be78-4126-b6bb-b74f31a45510" providerId="ADAL" clId="{9D7279F8-4830-4E52-8D06-5EEC883E0D3F}" dt="2025-09-29T15:31:32.212" v="2963"/>
      <pc:docMkLst>
        <pc:docMk/>
      </pc:docMkLst>
      <pc:sldChg chg="modSp mod">
        <pc:chgData name="Ben Price" userId="64e0ee70-be78-4126-b6bb-b74f31a45510" providerId="ADAL" clId="{9D7279F8-4830-4E52-8D06-5EEC883E0D3F}" dt="2025-09-18T14:14:41.565" v="1974" actId="20577"/>
        <pc:sldMkLst>
          <pc:docMk/>
          <pc:sldMk cId="893745816" sldId="256"/>
        </pc:sldMkLst>
        <pc:spChg chg="mod">
          <ac:chgData name="Ben Price" userId="64e0ee70-be78-4126-b6bb-b74f31a45510" providerId="ADAL" clId="{9D7279F8-4830-4E52-8D06-5EEC883E0D3F}" dt="2025-09-18T14:14:41.565" v="1974" actId="20577"/>
          <ac:spMkLst>
            <pc:docMk/>
            <pc:sldMk cId="893745816" sldId="256"/>
            <ac:spMk id="2" creationId="{59C1E245-9856-D9B0-AA67-0BDD89CB6F74}"/>
          </ac:spMkLst>
        </pc:spChg>
      </pc:sldChg>
      <pc:sldChg chg="addSp delSp modSp mod">
        <pc:chgData name="Ben Price" userId="64e0ee70-be78-4126-b6bb-b74f31a45510" providerId="ADAL" clId="{9D7279F8-4830-4E52-8D06-5EEC883E0D3F}" dt="2025-09-29T15:29:54.035" v="2947" actId="2711"/>
        <pc:sldMkLst>
          <pc:docMk/>
          <pc:sldMk cId="2864957517" sldId="257"/>
        </pc:sldMkLst>
        <pc:spChg chg="add mod">
          <ac:chgData name="Ben Price" userId="64e0ee70-be78-4126-b6bb-b74f31a45510" providerId="ADAL" clId="{9D7279F8-4830-4E52-8D06-5EEC883E0D3F}" dt="2025-09-25T10:39:51.670" v="2755" actId="20577"/>
          <ac:spMkLst>
            <pc:docMk/>
            <pc:sldMk cId="2864957517" sldId="257"/>
            <ac:spMk id="3" creationId="{9291717C-56E9-BFCC-A7B2-BF1A41849323}"/>
          </ac:spMkLst>
        </pc:spChg>
        <pc:spChg chg="add mod">
          <ac:chgData name="Ben Price" userId="64e0ee70-be78-4126-b6bb-b74f31a45510" providerId="ADAL" clId="{9D7279F8-4830-4E52-8D06-5EEC883E0D3F}" dt="2025-09-29T15:29:54.035" v="2947" actId="2711"/>
          <ac:spMkLst>
            <pc:docMk/>
            <pc:sldMk cId="2864957517" sldId="257"/>
            <ac:spMk id="11" creationId="{B62FC4DD-87F6-2642-7F89-C457E4937E85}"/>
          </ac:spMkLst>
        </pc:spChg>
        <pc:picChg chg="add mod modCrop">
          <ac:chgData name="Ben Price" userId="64e0ee70-be78-4126-b6bb-b74f31a45510" providerId="ADAL" clId="{9D7279F8-4830-4E52-8D06-5EEC883E0D3F}" dt="2025-09-18T14:15:52.442" v="1983" actId="1076"/>
          <ac:picMkLst>
            <pc:docMk/>
            <pc:sldMk cId="2864957517" sldId="257"/>
            <ac:picMk id="7" creationId="{8EA387E1-A68E-3ABB-CD03-61721CD47408}"/>
          </ac:picMkLst>
        </pc:picChg>
      </pc:sldChg>
      <pc:sldChg chg="addSp delSp modSp del mod">
        <pc:chgData name="Ben Price" userId="64e0ee70-be78-4126-b6bb-b74f31a45510" providerId="ADAL" clId="{9D7279F8-4830-4E52-8D06-5EEC883E0D3F}" dt="2025-09-19T11:03:32.830" v="2540" actId="47"/>
        <pc:sldMkLst>
          <pc:docMk/>
          <pc:sldMk cId="3946919736" sldId="258"/>
        </pc:sldMkLst>
      </pc:sldChg>
      <pc:sldChg chg="addSp delSp modSp mod">
        <pc:chgData name="Ben Price" userId="64e0ee70-be78-4126-b6bb-b74f31a45510" providerId="ADAL" clId="{9D7279F8-4830-4E52-8D06-5EEC883E0D3F}" dt="2025-09-29T15:30:03.764" v="2948"/>
        <pc:sldMkLst>
          <pc:docMk/>
          <pc:sldMk cId="2256538838" sldId="259"/>
        </pc:sldMkLst>
        <pc:spChg chg="mod">
          <ac:chgData name="Ben Price" userId="64e0ee70-be78-4126-b6bb-b74f31a45510" providerId="ADAL" clId="{9D7279F8-4830-4E52-8D06-5EEC883E0D3F}" dt="2025-09-18T12:37:59.114" v="177" actId="20577"/>
          <ac:spMkLst>
            <pc:docMk/>
            <pc:sldMk cId="2256538838" sldId="259"/>
            <ac:spMk id="3" creationId="{BA1A3B51-78B2-34A3-A256-42BA6ED97DAD}"/>
          </ac:spMkLst>
        </pc:spChg>
        <pc:spChg chg="add mod">
          <ac:chgData name="Ben Price" userId="64e0ee70-be78-4126-b6bb-b74f31a45510" providerId="ADAL" clId="{9D7279F8-4830-4E52-8D06-5EEC883E0D3F}" dt="2025-09-29T15:30:03.764" v="2948"/>
          <ac:spMkLst>
            <pc:docMk/>
            <pc:sldMk cId="2256538838" sldId="259"/>
            <ac:spMk id="4" creationId="{7947D1A3-7A24-5EBD-5D38-A02F962CF8EF}"/>
          </ac:spMkLst>
        </pc:spChg>
        <pc:spChg chg="add mod">
          <ac:chgData name="Ben Price" userId="64e0ee70-be78-4126-b6bb-b74f31a45510" providerId="ADAL" clId="{9D7279F8-4830-4E52-8D06-5EEC883E0D3F}" dt="2025-09-25T10:40:01.728" v="2757" actId="1076"/>
          <ac:spMkLst>
            <pc:docMk/>
            <pc:sldMk cId="2256538838" sldId="259"/>
            <ac:spMk id="6" creationId="{40D80A7E-B4FA-38FA-42FB-0F55BB5E6253}"/>
          </ac:spMkLst>
        </pc:spChg>
        <pc:picChg chg="mod modCrop">
          <ac:chgData name="Ben Price" userId="64e0ee70-be78-4126-b6bb-b74f31a45510" providerId="ADAL" clId="{9D7279F8-4830-4E52-8D06-5EEC883E0D3F}" dt="2025-09-18T14:17:01.580" v="2005" actId="1076"/>
          <ac:picMkLst>
            <pc:docMk/>
            <pc:sldMk cId="2256538838" sldId="259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30:10.606" v="2949"/>
        <pc:sldMkLst>
          <pc:docMk/>
          <pc:sldMk cId="3096298041" sldId="260"/>
        </pc:sldMkLst>
        <pc:spChg chg="add mod">
          <ac:chgData name="Ben Price" userId="64e0ee70-be78-4126-b6bb-b74f31a45510" providerId="ADAL" clId="{9D7279F8-4830-4E52-8D06-5EEC883E0D3F}" dt="2025-09-29T15:30:10.606" v="2949"/>
          <ac:spMkLst>
            <pc:docMk/>
            <pc:sldMk cId="3096298041" sldId="260"/>
            <ac:spMk id="3" creationId="{493F0C49-D4FB-FCD8-9323-BE80373DB0FF}"/>
          </ac:spMkLst>
        </pc:spChg>
        <pc:spChg chg="add mod">
          <ac:chgData name="Ben Price" userId="64e0ee70-be78-4126-b6bb-b74f31a45510" providerId="ADAL" clId="{9D7279F8-4830-4E52-8D06-5EEC883E0D3F}" dt="2025-09-25T10:40:16.929" v="2759" actId="1076"/>
          <ac:spMkLst>
            <pc:docMk/>
            <pc:sldMk cId="3096298041" sldId="260"/>
            <ac:spMk id="4" creationId="{E29D2B8C-D2DB-B08E-C8BA-D87CBD95DC33}"/>
          </ac:spMkLst>
        </pc:spChg>
        <pc:picChg chg="mod modCrop">
          <ac:chgData name="Ben Price" userId="64e0ee70-be78-4126-b6bb-b74f31a45510" providerId="ADAL" clId="{9D7279F8-4830-4E52-8D06-5EEC883E0D3F}" dt="2025-09-18T14:17:55.794" v="2011" actId="1076"/>
          <ac:picMkLst>
            <pc:docMk/>
            <pc:sldMk cId="3096298041" sldId="260"/>
            <ac:picMk id="5" creationId="{A07327A7-857E-E62B-FDF2-EC76549AD207}"/>
          </ac:picMkLst>
        </pc:picChg>
      </pc:sldChg>
      <pc:sldChg chg="addSp delSp modSp del mod">
        <pc:chgData name="Ben Price" userId="64e0ee70-be78-4126-b6bb-b74f31a45510" providerId="ADAL" clId="{9D7279F8-4830-4E52-8D06-5EEC883E0D3F}" dt="2025-09-18T13:58:48.493" v="1528" actId="47"/>
        <pc:sldMkLst>
          <pc:docMk/>
          <pc:sldMk cId="518143294" sldId="262"/>
        </pc:sldMkLst>
      </pc:sldChg>
      <pc:sldChg chg="addSp delSp modSp del mod">
        <pc:chgData name="Ben Price" userId="64e0ee70-be78-4126-b6bb-b74f31a45510" providerId="ADAL" clId="{9D7279F8-4830-4E52-8D06-5EEC883E0D3F}" dt="2025-09-18T13:58:58.835" v="1529" actId="47"/>
        <pc:sldMkLst>
          <pc:docMk/>
          <pc:sldMk cId="2401392754" sldId="263"/>
        </pc:sldMkLst>
      </pc:sldChg>
      <pc:sldChg chg="addSp delSp modSp mod">
        <pc:chgData name="Ben Price" userId="64e0ee70-be78-4126-b6bb-b74f31a45510" providerId="ADAL" clId="{9D7279F8-4830-4E52-8D06-5EEC883E0D3F}" dt="2025-09-29T15:26:36.801" v="2929" actId="2711"/>
        <pc:sldMkLst>
          <pc:docMk/>
          <pc:sldMk cId="2290877183" sldId="264"/>
        </pc:sldMkLst>
        <pc:spChg chg="mod">
          <ac:chgData name="Ben Price" userId="64e0ee70-be78-4126-b6bb-b74f31a45510" providerId="ADAL" clId="{9D7279F8-4830-4E52-8D06-5EEC883E0D3F}" dt="2025-09-18T14:20:42.179" v="2020" actId="20577"/>
          <ac:spMkLst>
            <pc:docMk/>
            <pc:sldMk cId="2290877183" sldId="264"/>
            <ac:spMk id="3" creationId="{A26699F5-1F96-5486-40A1-438AC6CE63B8}"/>
          </ac:spMkLst>
        </pc:spChg>
        <pc:spChg chg="add mod">
          <ac:chgData name="Ben Price" userId="64e0ee70-be78-4126-b6bb-b74f31a45510" providerId="ADAL" clId="{9D7279F8-4830-4E52-8D06-5EEC883E0D3F}" dt="2025-09-25T10:44:03.204" v="2867" actId="1036"/>
          <ac:spMkLst>
            <pc:docMk/>
            <pc:sldMk cId="2290877183" sldId="264"/>
            <ac:spMk id="4" creationId="{C5D47DAF-2EAE-E3EE-93BC-F9DD92FD1553}"/>
          </ac:spMkLst>
        </pc:spChg>
        <pc:spChg chg="add mod">
          <ac:chgData name="Ben Price" userId="64e0ee70-be78-4126-b6bb-b74f31a45510" providerId="ADAL" clId="{9D7279F8-4830-4E52-8D06-5EEC883E0D3F}" dt="2025-09-29T15:26:36.801" v="2929" actId="2711"/>
          <ac:spMkLst>
            <pc:docMk/>
            <pc:sldMk cId="2290877183" sldId="264"/>
            <ac:spMk id="7" creationId="{96E53075-1172-A112-1BF0-DBDA9F40C4E7}"/>
          </ac:spMkLst>
        </pc:spChg>
        <pc:picChg chg="mod modCrop">
          <ac:chgData name="Ben Price" userId="64e0ee70-be78-4126-b6bb-b74f31a45510" providerId="ADAL" clId="{9D7279F8-4830-4E52-8D06-5EEC883E0D3F}" dt="2025-09-25T10:43:45.329" v="2851" actId="1076"/>
          <ac:picMkLst>
            <pc:docMk/>
            <pc:sldMk cId="2290877183" sldId="264"/>
            <ac:picMk id="5" creationId="{A07327A7-857E-E62B-FDF2-EC76549AD207}"/>
          </ac:picMkLst>
        </pc:picChg>
      </pc:sldChg>
      <pc:sldChg chg="addSp delSp modSp del mod">
        <pc:chgData name="Ben Price" userId="64e0ee70-be78-4126-b6bb-b74f31a45510" providerId="ADAL" clId="{9D7279F8-4830-4E52-8D06-5EEC883E0D3F}" dt="2025-09-18T13:59:05.654" v="1530" actId="47"/>
        <pc:sldMkLst>
          <pc:docMk/>
          <pc:sldMk cId="444016717" sldId="265"/>
        </pc:sldMkLst>
      </pc:sldChg>
      <pc:sldChg chg="addSp delSp modSp del mod">
        <pc:chgData name="Ben Price" userId="64e0ee70-be78-4126-b6bb-b74f31a45510" providerId="ADAL" clId="{9D7279F8-4830-4E52-8D06-5EEC883E0D3F}" dt="2025-09-18T13:59:09.548" v="1531" actId="47"/>
        <pc:sldMkLst>
          <pc:docMk/>
          <pc:sldMk cId="2927916576" sldId="266"/>
        </pc:sldMkLst>
      </pc:sldChg>
      <pc:sldChg chg="addSp delSp modSp mod">
        <pc:chgData name="Ben Price" userId="64e0ee70-be78-4126-b6bb-b74f31a45510" providerId="ADAL" clId="{9D7279F8-4830-4E52-8D06-5EEC883E0D3F}" dt="2025-09-29T15:26:47.811" v="2930"/>
        <pc:sldMkLst>
          <pc:docMk/>
          <pc:sldMk cId="801077105" sldId="267"/>
        </pc:sldMkLst>
        <pc:spChg chg="mod">
          <ac:chgData name="Ben Price" userId="64e0ee70-be78-4126-b6bb-b74f31a45510" providerId="ADAL" clId="{9D7279F8-4830-4E52-8D06-5EEC883E0D3F}" dt="2025-09-18T14:21:30.170" v="2031" actId="1076"/>
          <ac:spMkLst>
            <pc:docMk/>
            <pc:sldMk cId="801077105" sldId="267"/>
            <ac:spMk id="3" creationId="{4B5DEA3B-801C-4EC6-DA86-88DDEFDA0AC3}"/>
          </ac:spMkLst>
        </pc:spChg>
        <pc:spChg chg="add mod">
          <ac:chgData name="Ben Price" userId="64e0ee70-be78-4126-b6bb-b74f31a45510" providerId="ADAL" clId="{9D7279F8-4830-4E52-8D06-5EEC883E0D3F}" dt="2025-09-29T15:26:47.811" v="2930"/>
          <ac:spMkLst>
            <pc:docMk/>
            <pc:sldMk cId="801077105" sldId="267"/>
            <ac:spMk id="4" creationId="{74C2326E-2C86-E736-1180-EA6AC2CC8683}"/>
          </ac:spMkLst>
        </pc:spChg>
        <pc:spChg chg="add mod">
          <ac:chgData name="Ben Price" userId="64e0ee70-be78-4126-b6bb-b74f31a45510" providerId="ADAL" clId="{9D7279F8-4830-4E52-8D06-5EEC883E0D3F}" dt="2025-09-25T10:44:13.264" v="2869" actId="1076"/>
          <ac:spMkLst>
            <pc:docMk/>
            <pc:sldMk cId="801077105" sldId="267"/>
            <ac:spMk id="6" creationId="{7B060E7B-AFEC-C4A5-FA9E-8E13ED9868B9}"/>
          </ac:spMkLst>
        </pc:spChg>
        <pc:picChg chg="mod modCrop">
          <ac:chgData name="Ben Price" userId="64e0ee70-be78-4126-b6bb-b74f31a45510" providerId="ADAL" clId="{9D7279F8-4830-4E52-8D06-5EEC883E0D3F}" dt="2025-09-18T14:21:27.569" v="2030" actId="1076"/>
          <ac:picMkLst>
            <pc:docMk/>
            <pc:sldMk cId="801077105" sldId="267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26:55.122" v="2931"/>
        <pc:sldMkLst>
          <pc:docMk/>
          <pc:sldMk cId="2168095722" sldId="268"/>
        </pc:sldMkLst>
        <pc:spChg chg="add mod">
          <ac:chgData name="Ben Price" userId="64e0ee70-be78-4126-b6bb-b74f31a45510" providerId="ADAL" clId="{9D7279F8-4830-4E52-8D06-5EEC883E0D3F}" dt="2025-09-25T10:44:19.428" v="2871" actId="1076"/>
          <ac:spMkLst>
            <pc:docMk/>
            <pc:sldMk cId="2168095722" sldId="268"/>
            <ac:spMk id="2" creationId="{43102979-0D5B-ED49-4BFF-C4DE907F9701}"/>
          </ac:spMkLst>
        </pc:spChg>
        <pc:spChg chg="add mod">
          <ac:chgData name="Ben Price" userId="64e0ee70-be78-4126-b6bb-b74f31a45510" providerId="ADAL" clId="{9D7279F8-4830-4E52-8D06-5EEC883E0D3F}" dt="2025-09-29T15:26:55.122" v="2931"/>
          <ac:spMkLst>
            <pc:docMk/>
            <pc:sldMk cId="2168095722" sldId="268"/>
            <ac:spMk id="3" creationId="{BBBFA1BA-5380-00DA-21ED-DFAD5B064D9B}"/>
          </ac:spMkLst>
        </pc:spChg>
        <pc:spChg chg="mod">
          <ac:chgData name="Ben Price" userId="64e0ee70-be78-4126-b6bb-b74f31a45510" providerId="ADAL" clId="{9D7279F8-4830-4E52-8D06-5EEC883E0D3F}" dt="2025-09-18T14:23:58.243" v="2044" actId="1076"/>
          <ac:spMkLst>
            <pc:docMk/>
            <pc:sldMk cId="2168095722" sldId="268"/>
            <ac:spMk id="4" creationId="{4362D523-CDD9-158C-6F0B-EB11429A3B40}"/>
          </ac:spMkLst>
        </pc:spChg>
        <pc:picChg chg="mod modCrop">
          <ac:chgData name="Ben Price" userId="64e0ee70-be78-4126-b6bb-b74f31a45510" providerId="ADAL" clId="{9D7279F8-4830-4E52-8D06-5EEC883E0D3F}" dt="2025-09-18T14:23:54.850" v="2043" actId="1076"/>
          <ac:picMkLst>
            <pc:docMk/>
            <pc:sldMk cId="2168095722" sldId="268"/>
            <ac:picMk id="5" creationId="{A07327A7-857E-E62B-FDF2-EC76549AD207}"/>
          </ac:picMkLst>
        </pc:picChg>
      </pc:sldChg>
      <pc:sldChg chg="addSp delSp modSp add del mod ord">
        <pc:chgData name="Ben Price" userId="64e0ee70-be78-4126-b6bb-b74f31a45510" providerId="ADAL" clId="{9D7279F8-4830-4E52-8D06-5EEC883E0D3F}" dt="2025-09-18T14:30:23.392" v="2107" actId="47"/>
        <pc:sldMkLst>
          <pc:docMk/>
          <pc:sldMk cId="3593437801" sldId="269"/>
        </pc:sldMkLst>
      </pc:sldChg>
      <pc:sldChg chg="addSp modSp del mod">
        <pc:chgData name="Ben Price" userId="64e0ee70-be78-4126-b6bb-b74f31a45510" providerId="ADAL" clId="{9D7279F8-4830-4E52-8D06-5EEC883E0D3F}" dt="2025-09-18T13:05:22.614" v="802" actId="47"/>
        <pc:sldMkLst>
          <pc:docMk/>
          <pc:sldMk cId="756201150" sldId="270"/>
        </pc:sldMkLst>
      </pc:sldChg>
      <pc:sldChg chg="addSp delSp modSp del mod">
        <pc:chgData name="Ben Price" userId="64e0ee70-be78-4126-b6bb-b74f31a45510" providerId="ADAL" clId="{9D7279F8-4830-4E52-8D06-5EEC883E0D3F}" dt="2025-09-18T14:30:49.316" v="2108" actId="47"/>
        <pc:sldMkLst>
          <pc:docMk/>
          <pc:sldMk cId="1397535773" sldId="272"/>
        </pc:sldMkLst>
      </pc:sldChg>
      <pc:sldChg chg="addSp delSp modSp del mod">
        <pc:chgData name="Ben Price" userId="64e0ee70-be78-4126-b6bb-b74f31a45510" providerId="ADAL" clId="{9D7279F8-4830-4E52-8D06-5EEC883E0D3F}" dt="2025-09-18T14:29:38.807" v="2102" actId="47"/>
        <pc:sldMkLst>
          <pc:docMk/>
          <pc:sldMk cId="600024648" sldId="273"/>
        </pc:sldMkLst>
      </pc:sldChg>
      <pc:sldChg chg="addSp delSp modSp mod">
        <pc:chgData name="Ben Price" userId="64e0ee70-be78-4126-b6bb-b74f31a45510" providerId="ADAL" clId="{9D7279F8-4830-4E52-8D06-5EEC883E0D3F}" dt="2025-09-29T15:30:21.202" v="2950"/>
        <pc:sldMkLst>
          <pc:docMk/>
          <pc:sldMk cId="2276253020" sldId="274"/>
        </pc:sldMkLst>
        <pc:spChg chg="add mod">
          <ac:chgData name="Ben Price" userId="64e0ee70-be78-4126-b6bb-b74f31a45510" providerId="ADAL" clId="{9D7279F8-4830-4E52-8D06-5EEC883E0D3F}" dt="2025-09-25T10:40:31.026" v="2761" actId="1076"/>
          <ac:spMkLst>
            <pc:docMk/>
            <pc:sldMk cId="2276253020" sldId="274"/>
            <ac:spMk id="2" creationId="{197B2A83-9D14-B3B7-3CB0-453E01F42962}"/>
          </ac:spMkLst>
        </pc:spChg>
        <pc:spChg chg="add mod">
          <ac:chgData name="Ben Price" userId="64e0ee70-be78-4126-b6bb-b74f31a45510" providerId="ADAL" clId="{9D7279F8-4830-4E52-8D06-5EEC883E0D3F}" dt="2025-09-29T15:30:21.202" v="2950"/>
          <ac:spMkLst>
            <pc:docMk/>
            <pc:sldMk cId="2276253020" sldId="274"/>
            <ac:spMk id="3" creationId="{73CAB7D8-64C5-CF34-BB6C-15693D326DA9}"/>
          </ac:spMkLst>
        </pc:spChg>
        <pc:picChg chg="mod modCrop">
          <ac:chgData name="Ben Price" userId="64e0ee70-be78-4126-b6bb-b74f31a45510" providerId="ADAL" clId="{9D7279F8-4830-4E52-8D06-5EEC883E0D3F}" dt="2025-09-18T14:31:44.520" v="2118" actId="1076"/>
          <ac:picMkLst>
            <pc:docMk/>
            <pc:sldMk cId="2276253020" sldId="274"/>
            <ac:picMk id="5" creationId="{A07327A7-857E-E62B-FDF2-EC76549AD207}"/>
          </ac:picMkLst>
        </pc:picChg>
      </pc:sldChg>
      <pc:sldChg chg="addSp delSp modSp mod ord">
        <pc:chgData name="Ben Price" userId="64e0ee70-be78-4126-b6bb-b74f31a45510" providerId="ADAL" clId="{9D7279F8-4830-4E52-8D06-5EEC883E0D3F}" dt="2025-09-29T15:30:26.264" v="2951"/>
        <pc:sldMkLst>
          <pc:docMk/>
          <pc:sldMk cId="3738433072" sldId="275"/>
        </pc:sldMkLst>
        <pc:spChg chg="add mod">
          <ac:chgData name="Ben Price" userId="64e0ee70-be78-4126-b6bb-b74f31a45510" providerId="ADAL" clId="{9D7279F8-4830-4E52-8D06-5EEC883E0D3F}" dt="2025-09-25T10:44:32.546" v="2890" actId="1036"/>
          <ac:spMkLst>
            <pc:docMk/>
            <pc:sldMk cId="3738433072" sldId="275"/>
            <ac:spMk id="2" creationId="{D094CD7A-1060-808F-3039-C5BEA063A4C9}"/>
          </ac:spMkLst>
        </pc:spChg>
        <pc:spChg chg="mod">
          <ac:chgData name="Ben Price" userId="64e0ee70-be78-4126-b6bb-b74f31a45510" providerId="ADAL" clId="{9D7279F8-4830-4E52-8D06-5EEC883E0D3F}" dt="2025-09-18T14:32:48.339" v="2128" actId="1076"/>
          <ac:spMkLst>
            <pc:docMk/>
            <pc:sldMk cId="3738433072" sldId="275"/>
            <ac:spMk id="3" creationId="{4B5DEA3B-801C-4EC6-DA86-88DDEFDA0AC3}"/>
          </ac:spMkLst>
        </pc:spChg>
        <pc:spChg chg="add mod">
          <ac:chgData name="Ben Price" userId="64e0ee70-be78-4126-b6bb-b74f31a45510" providerId="ADAL" clId="{9D7279F8-4830-4E52-8D06-5EEC883E0D3F}" dt="2025-09-29T15:30:26.264" v="2951"/>
          <ac:spMkLst>
            <pc:docMk/>
            <pc:sldMk cId="3738433072" sldId="275"/>
            <ac:spMk id="4" creationId="{F7A1ED97-35E3-1CE6-021C-6A38958E1842}"/>
          </ac:spMkLst>
        </pc:spChg>
        <pc:picChg chg="mod modCrop">
          <ac:chgData name="Ben Price" userId="64e0ee70-be78-4126-b6bb-b74f31a45510" providerId="ADAL" clId="{9D7279F8-4830-4E52-8D06-5EEC883E0D3F}" dt="2025-09-25T10:44:32.546" v="2890" actId="1036"/>
          <ac:picMkLst>
            <pc:docMk/>
            <pc:sldMk cId="3738433072" sldId="275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30:29.437" v="2952"/>
        <pc:sldMkLst>
          <pc:docMk/>
          <pc:sldMk cId="3678121570" sldId="276"/>
        </pc:sldMkLst>
        <pc:spChg chg="add mod">
          <ac:chgData name="Ben Price" userId="64e0ee70-be78-4126-b6bb-b74f31a45510" providerId="ADAL" clId="{9D7279F8-4830-4E52-8D06-5EEC883E0D3F}" dt="2025-09-25T10:40:53.366" v="2799" actId="1076"/>
          <ac:spMkLst>
            <pc:docMk/>
            <pc:sldMk cId="3678121570" sldId="276"/>
            <ac:spMk id="2" creationId="{25073C2D-7683-703C-37BE-55B21C28DD69}"/>
          </ac:spMkLst>
        </pc:spChg>
        <pc:spChg chg="add mod">
          <ac:chgData name="Ben Price" userId="64e0ee70-be78-4126-b6bb-b74f31a45510" providerId="ADAL" clId="{9D7279F8-4830-4E52-8D06-5EEC883E0D3F}" dt="2025-09-29T15:30:29.437" v="2952"/>
          <ac:spMkLst>
            <pc:docMk/>
            <pc:sldMk cId="3678121570" sldId="276"/>
            <ac:spMk id="3" creationId="{81ADD624-E0BF-7BAB-D9B5-CC045598B484}"/>
          </ac:spMkLst>
        </pc:spChg>
        <pc:spChg chg="mod">
          <ac:chgData name="Ben Price" userId="64e0ee70-be78-4126-b6bb-b74f31a45510" providerId="ADAL" clId="{9D7279F8-4830-4E52-8D06-5EEC883E0D3F}" dt="2025-09-19T11:09:21.604" v="2615" actId="20577"/>
          <ac:spMkLst>
            <pc:docMk/>
            <pc:sldMk cId="3678121570" sldId="276"/>
            <ac:spMk id="4" creationId="{4362D523-CDD9-158C-6F0B-EB11429A3B40}"/>
          </ac:spMkLst>
        </pc:spChg>
        <pc:picChg chg="mod modCrop">
          <ac:chgData name="Ben Price" userId="64e0ee70-be78-4126-b6bb-b74f31a45510" providerId="ADAL" clId="{9D7279F8-4830-4E52-8D06-5EEC883E0D3F}" dt="2025-09-25T10:40:50.143" v="2798" actId="1076"/>
          <ac:picMkLst>
            <pc:docMk/>
            <pc:sldMk cId="3678121570" sldId="276"/>
            <ac:picMk id="5" creationId="{A07327A7-857E-E62B-FDF2-EC76549AD207}"/>
          </ac:picMkLst>
        </pc:picChg>
      </pc:sldChg>
      <pc:sldChg chg="addSp delSp modSp del mod">
        <pc:chgData name="Ben Price" userId="64e0ee70-be78-4126-b6bb-b74f31a45510" providerId="ADAL" clId="{9D7279F8-4830-4E52-8D06-5EEC883E0D3F}" dt="2025-09-18T14:34:21.434" v="2142" actId="47"/>
        <pc:sldMkLst>
          <pc:docMk/>
          <pc:sldMk cId="3012135928" sldId="277"/>
        </pc:sldMkLst>
      </pc:sldChg>
      <pc:sldChg chg="addSp delSp modSp mod">
        <pc:chgData name="Ben Price" userId="64e0ee70-be78-4126-b6bb-b74f31a45510" providerId="ADAL" clId="{9D7279F8-4830-4E52-8D06-5EEC883E0D3F}" dt="2025-09-29T15:30:34.409" v="2953"/>
        <pc:sldMkLst>
          <pc:docMk/>
          <pc:sldMk cId="2559390613" sldId="278"/>
        </pc:sldMkLst>
        <pc:spChg chg="add mod">
          <ac:chgData name="Ben Price" userId="64e0ee70-be78-4126-b6bb-b74f31a45510" providerId="ADAL" clId="{9D7279F8-4830-4E52-8D06-5EEC883E0D3F}" dt="2025-09-25T10:41:01.951" v="2801" actId="1076"/>
          <ac:spMkLst>
            <pc:docMk/>
            <pc:sldMk cId="2559390613" sldId="278"/>
            <ac:spMk id="2" creationId="{B0890503-77AA-B7CC-748F-86B5AFE602C9}"/>
          </ac:spMkLst>
        </pc:spChg>
        <pc:spChg chg="add mod">
          <ac:chgData name="Ben Price" userId="64e0ee70-be78-4126-b6bb-b74f31a45510" providerId="ADAL" clId="{9D7279F8-4830-4E52-8D06-5EEC883E0D3F}" dt="2025-09-29T15:30:34.409" v="2953"/>
          <ac:spMkLst>
            <pc:docMk/>
            <pc:sldMk cId="2559390613" sldId="278"/>
            <ac:spMk id="3" creationId="{D2CD0A97-722E-893A-7224-33D775CB59F7}"/>
          </ac:spMkLst>
        </pc:spChg>
        <pc:picChg chg="mod modCrop">
          <ac:chgData name="Ben Price" userId="64e0ee70-be78-4126-b6bb-b74f31a45510" providerId="ADAL" clId="{9D7279F8-4830-4E52-8D06-5EEC883E0D3F}" dt="2025-09-18T14:34:48.856" v="2147" actId="14100"/>
          <ac:picMkLst>
            <pc:docMk/>
            <pc:sldMk cId="2559390613" sldId="278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30:37.649" v="2954"/>
        <pc:sldMkLst>
          <pc:docMk/>
          <pc:sldMk cId="2629514977" sldId="279"/>
        </pc:sldMkLst>
        <pc:spChg chg="add mod">
          <ac:chgData name="Ben Price" userId="64e0ee70-be78-4126-b6bb-b74f31a45510" providerId="ADAL" clId="{9D7279F8-4830-4E52-8D06-5EEC883E0D3F}" dt="2025-09-25T10:41:15.258" v="2804" actId="1076"/>
          <ac:spMkLst>
            <pc:docMk/>
            <pc:sldMk cId="2629514977" sldId="279"/>
            <ac:spMk id="2" creationId="{B838DBB6-8BCD-22E7-AAC4-DB4BE313BF37}"/>
          </ac:spMkLst>
        </pc:spChg>
        <pc:spChg chg="mod">
          <ac:chgData name="Ben Price" userId="64e0ee70-be78-4126-b6bb-b74f31a45510" providerId="ADAL" clId="{9D7279F8-4830-4E52-8D06-5EEC883E0D3F}" dt="2025-09-18T14:35:47.060" v="2158" actId="1076"/>
          <ac:spMkLst>
            <pc:docMk/>
            <pc:sldMk cId="2629514977" sldId="279"/>
            <ac:spMk id="3" creationId="{A26699F5-1F96-5486-40A1-438AC6CE63B8}"/>
          </ac:spMkLst>
        </pc:spChg>
        <pc:spChg chg="add mod">
          <ac:chgData name="Ben Price" userId="64e0ee70-be78-4126-b6bb-b74f31a45510" providerId="ADAL" clId="{9D7279F8-4830-4E52-8D06-5EEC883E0D3F}" dt="2025-09-29T15:30:37.649" v="2954"/>
          <ac:spMkLst>
            <pc:docMk/>
            <pc:sldMk cId="2629514977" sldId="279"/>
            <ac:spMk id="7" creationId="{6509314B-EDE3-BFF6-6C94-21694A0FA9B7}"/>
          </ac:spMkLst>
        </pc:spChg>
        <pc:picChg chg="mod modCrop">
          <ac:chgData name="Ben Price" userId="64e0ee70-be78-4126-b6bb-b74f31a45510" providerId="ADAL" clId="{9D7279F8-4830-4E52-8D06-5EEC883E0D3F}" dt="2025-09-25T10:41:10.954" v="2802" actId="1076"/>
          <ac:picMkLst>
            <pc:docMk/>
            <pc:sldMk cId="2629514977" sldId="279"/>
            <ac:picMk id="5" creationId="{A07327A7-857E-E62B-FDF2-EC76549AD207}"/>
          </ac:picMkLst>
        </pc:picChg>
      </pc:sldChg>
      <pc:sldChg chg="addSp delSp modSp del mod">
        <pc:chgData name="Ben Price" userId="64e0ee70-be78-4126-b6bb-b74f31a45510" providerId="ADAL" clId="{9D7279F8-4830-4E52-8D06-5EEC883E0D3F}" dt="2025-09-18T14:36:37.752" v="2159" actId="47"/>
        <pc:sldMkLst>
          <pc:docMk/>
          <pc:sldMk cId="809103216" sldId="280"/>
        </pc:sldMkLst>
      </pc:sldChg>
      <pc:sldChg chg="addSp delSp modSp mod">
        <pc:chgData name="Ben Price" userId="64e0ee70-be78-4126-b6bb-b74f31a45510" providerId="ADAL" clId="{9D7279F8-4830-4E52-8D06-5EEC883E0D3F}" dt="2025-09-29T15:30:43.006" v="2955"/>
        <pc:sldMkLst>
          <pc:docMk/>
          <pc:sldMk cId="2086721289" sldId="281"/>
        </pc:sldMkLst>
        <pc:spChg chg="add mod">
          <ac:chgData name="Ben Price" userId="64e0ee70-be78-4126-b6bb-b74f31a45510" providerId="ADAL" clId="{9D7279F8-4830-4E52-8D06-5EEC883E0D3F}" dt="2025-09-25T10:41:21.728" v="2806" actId="1076"/>
          <ac:spMkLst>
            <pc:docMk/>
            <pc:sldMk cId="2086721289" sldId="281"/>
            <ac:spMk id="2" creationId="{1A066CBF-F102-B080-622A-CE601CF9E63E}"/>
          </ac:spMkLst>
        </pc:spChg>
        <pc:spChg chg="add mod">
          <ac:chgData name="Ben Price" userId="64e0ee70-be78-4126-b6bb-b74f31a45510" providerId="ADAL" clId="{9D7279F8-4830-4E52-8D06-5EEC883E0D3F}" dt="2025-09-29T15:30:43.006" v="2955"/>
          <ac:spMkLst>
            <pc:docMk/>
            <pc:sldMk cId="2086721289" sldId="281"/>
            <ac:spMk id="3" creationId="{B659F9D8-4A6B-E0B9-6607-FD19AF1C684B}"/>
          </ac:spMkLst>
        </pc:spChg>
        <pc:picChg chg="mod modCrop">
          <ac:chgData name="Ben Price" userId="64e0ee70-be78-4126-b6bb-b74f31a45510" providerId="ADAL" clId="{9D7279F8-4830-4E52-8D06-5EEC883E0D3F}" dt="2025-09-18T14:37:21.410" v="2171" actId="1076"/>
          <ac:picMkLst>
            <pc:docMk/>
            <pc:sldMk cId="2086721289" sldId="281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30:49.015" v="2956"/>
        <pc:sldMkLst>
          <pc:docMk/>
          <pc:sldMk cId="1612584656" sldId="282"/>
        </pc:sldMkLst>
        <pc:spChg chg="add mod">
          <ac:chgData name="Ben Price" userId="64e0ee70-be78-4126-b6bb-b74f31a45510" providerId="ADAL" clId="{9D7279F8-4830-4E52-8D06-5EEC883E0D3F}" dt="2025-09-25T10:41:37.433" v="2812" actId="1076"/>
          <ac:spMkLst>
            <pc:docMk/>
            <pc:sldMk cId="1612584656" sldId="282"/>
            <ac:spMk id="2" creationId="{79877477-7860-8528-07D7-E8F83B61E72C}"/>
          </ac:spMkLst>
        </pc:spChg>
        <pc:spChg chg="add mod">
          <ac:chgData name="Ben Price" userId="64e0ee70-be78-4126-b6bb-b74f31a45510" providerId="ADAL" clId="{9D7279F8-4830-4E52-8D06-5EEC883E0D3F}" dt="2025-09-29T15:30:49.015" v="2956"/>
          <ac:spMkLst>
            <pc:docMk/>
            <pc:sldMk cId="1612584656" sldId="282"/>
            <ac:spMk id="3" creationId="{93D13C0F-4199-B134-3023-04761D605E99}"/>
          </ac:spMkLst>
        </pc:spChg>
        <pc:picChg chg="mod modCrop">
          <ac:chgData name="Ben Price" userId="64e0ee70-be78-4126-b6bb-b74f31a45510" providerId="ADAL" clId="{9D7279F8-4830-4E52-8D06-5EEC883E0D3F}" dt="2025-09-25T10:41:33.597" v="2811" actId="1076"/>
          <ac:picMkLst>
            <pc:docMk/>
            <pc:sldMk cId="1612584656" sldId="282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30:52.656" v="2957"/>
        <pc:sldMkLst>
          <pc:docMk/>
          <pc:sldMk cId="305824627" sldId="284"/>
        </pc:sldMkLst>
        <pc:spChg chg="add mod">
          <ac:chgData name="Ben Price" userId="64e0ee70-be78-4126-b6bb-b74f31a45510" providerId="ADAL" clId="{9D7279F8-4830-4E52-8D06-5EEC883E0D3F}" dt="2025-09-25T10:41:58.616" v="2825" actId="1076"/>
          <ac:spMkLst>
            <pc:docMk/>
            <pc:sldMk cId="305824627" sldId="284"/>
            <ac:spMk id="2" creationId="{ACDE6DAE-5F3E-E7C6-2591-8D0E6B27F2E0}"/>
          </ac:spMkLst>
        </pc:spChg>
        <pc:spChg chg="mod">
          <ac:chgData name="Ben Price" userId="64e0ee70-be78-4126-b6bb-b74f31a45510" providerId="ADAL" clId="{9D7279F8-4830-4E52-8D06-5EEC883E0D3F}" dt="2025-09-18T14:38:53.786" v="2188" actId="1076"/>
          <ac:spMkLst>
            <pc:docMk/>
            <pc:sldMk cId="305824627" sldId="284"/>
            <ac:spMk id="3" creationId="{4B5DEA3B-801C-4EC6-DA86-88DDEFDA0AC3}"/>
          </ac:spMkLst>
        </pc:spChg>
        <pc:spChg chg="add mod">
          <ac:chgData name="Ben Price" userId="64e0ee70-be78-4126-b6bb-b74f31a45510" providerId="ADAL" clId="{9D7279F8-4830-4E52-8D06-5EEC883E0D3F}" dt="2025-09-29T15:30:52.656" v="2957"/>
          <ac:spMkLst>
            <pc:docMk/>
            <pc:sldMk cId="305824627" sldId="284"/>
            <ac:spMk id="4" creationId="{9DD3023F-584C-DDD4-5101-7BEDFC899ABE}"/>
          </ac:spMkLst>
        </pc:spChg>
        <pc:picChg chg="mod modCrop">
          <ac:chgData name="Ben Price" userId="64e0ee70-be78-4126-b6bb-b74f31a45510" providerId="ADAL" clId="{9D7279F8-4830-4E52-8D06-5EEC883E0D3F}" dt="2025-09-25T10:41:54.403" v="2823" actId="1076"/>
          <ac:picMkLst>
            <pc:docMk/>
            <pc:sldMk cId="305824627" sldId="284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30:57.607" v="2958"/>
        <pc:sldMkLst>
          <pc:docMk/>
          <pc:sldMk cId="3931762510" sldId="285"/>
        </pc:sldMkLst>
        <pc:spChg chg="add mod">
          <ac:chgData name="Ben Price" userId="64e0ee70-be78-4126-b6bb-b74f31a45510" providerId="ADAL" clId="{9D7279F8-4830-4E52-8D06-5EEC883E0D3F}" dt="2025-09-25T10:42:11.083" v="2831" actId="1036"/>
          <ac:spMkLst>
            <pc:docMk/>
            <pc:sldMk cId="3931762510" sldId="285"/>
            <ac:spMk id="2" creationId="{E02EA6D8-CEEF-06AF-96BD-344F5D7B633C}"/>
          </ac:spMkLst>
        </pc:spChg>
        <pc:spChg chg="add mod">
          <ac:chgData name="Ben Price" userId="64e0ee70-be78-4126-b6bb-b74f31a45510" providerId="ADAL" clId="{9D7279F8-4830-4E52-8D06-5EEC883E0D3F}" dt="2025-09-29T15:30:57.607" v="2958"/>
          <ac:spMkLst>
            <pc:docMk/>
            <pc:sldMk cId="3931762510" sldId="285"/>
            <ac:spMk id="3" creationId="{DA84897B-CBD7-ED7B-3DA7-1DF31C1A1881}"/>
          </ac:spMkLst>
        </pc:spChg>
        <pc:picChg chg="mod modCrop">
          <ac:chgData name="Ben Price" userId="64e0ee70-be78-4126-b6bb-b74f31a45510" providerId="ADAL" clId="{9D7279F8-4830-4E52-8D06-5EEC883E0D3F}" dt="2025-09-18T14:39:47.915" v="2202" actId="1076"/>
          <ac:picMkLst>
            <pc:docMk/>
            <pc:sldMk cId="3931762510" sldId="285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31:03.323" v="2959"/>
        <pc:sldMkLst>
          <pc:docMk/>
          <pc:sldMk cId="2160345174" sldId="286"/>
        </pc:sldMkLst>
        <pc:spChg chg="add mod">
          <ac:chgData name="Ben Price" userId="64e0ee70-be78-4126-b6bb-b74f31a45510" providerId="ADAL" clId="{9D7279F8-4830-4E52-8D06-5EEC883E0D3F}" dt="2025-09-25T10:42:19.849" v="2834" actId="1076"/>
          <ac:spMkLst>
            <pc:docMk/>
            <pc:sldMk cId="2160345174" sldId="286"/>
            <ac:spMk id="2" creationId="{D0DBC17D-AF21-A6FE-87DD-A89EAD6728D2}"/>
          </ac:spMkLst>
        </pc:spChg>
        <pc:spChg chg="add mod">
          <ac:chgData name="Ben Price" userId="64e0ee70-be78-4126-b6bb-b74f31a45510" providerId="ADAL" clId="{9D7279F8-4830-4E52-8D06-5EEC883E0D3F}" dt="2025-09-29T15:31:03.323" v="2959"/>
          <ac:spMkLst>
            <pc:docMk/>
            <pc:sldMk cId="2160345174" sldId="286"/>
            <ac:spMk id="4" creationId="{BD081EB1-7DD2-0ABD-3D42-138FE71B6735}"/>
          </ac:spMkLst>
        </pc:spChg>
        <pc:picChg chg="mod modCrop">
          <ac:chgData name="Ben Price" userId="64e0ee70-be78-4126-b6bb-b74f31a45510" providerId="ADAL" clId="{9D7279F8-4830-4E52-8D06-5EEC883E0D3F}" dt="2025-09-25T10:42:15.845" v="2832" actId="1076"/>
          <ac:picMkLst>
            <pc:docMk/>
            <pc:sldMk cId="2160345174" sldId="286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31:06.741" v="2960"/>
        <pc:sldMkLst>
          <pc:docMk/>
          <pc:sldMk cId="3237148080" sldId="288"/>
        </pc:sldMkLst>
        <pc:spChg chg="add mod">
          <ac:chgData name="Ben Price" userId="64e0ee70-be78-4126-b6bb-b74f31a45510" providerId="ADAL" clId="{9D7279F8-4830-4E52-8D06-5EEC883E0D3F}" dt="2025-09-25T10:42:34.264" v="2837" actId="1076"/>
          <ac:spMkLst>
            <pc:docMk/>
            <pc:sldMk cId="3237148080" sldId="288"/>
            <ac:spMk id="2" creationId="{4ECDECD4-5B0E-7FCF-BDE8-AC64677B12FA}"/>
          </ac:spMkLst>
        </pc:spChg>
        <pc:spChg chg="mod">
          <ac:chgData name="Ben Price" userId="64e0ee70-be78-4126-b6bb-b74f31a45510" providerId="ADAL" clId="{9D7279F8-4830-4E52-8D06-5EEC883E0D3F}" dt="2025-09-18T14:41:35.836" v="2224" actId="1076"/>
          <ac:spMkLst>
            <pc:docMk/>
            <pc:sldMk cId="3237148080" sldId="288"/>
            <ac:spMk id="3" creationId="{4B5DEA3B-801C-4EC6-DA86-88DDEFDA0AC3}"/>
          </ac:spMkLst>
        </pc:spChg>
        <pc:spChg chg="add mod">
          <ac:chgData name="Ben Price" userId="64e0ee70-be78-4126-b6bb-b74f31a45510" providerId="ADAL" clId="{9D7279F8-4830-4E52-8D06-5EEC883E0D3F}" dt="2025-09-29T15:31:06.741" v="2960"/>
          <ac:spMkLst>
            <pc:docMk/>
            <pc:sldMk cId="3237148080" sldId="288"/>
            <ac:spMk id="4" creationId="{60A7626A-C175-13C1-21B9-B6F0E2321A20}"/>
          </ac:spMkLst>
        </pc:spChg>
        <pc:picChg chg="mod modCrop">
          <ac:chgData name="Ben Price" userId="64e0ee70-be78-4126-b6bb-b74f31a45510" providerId="ADAL" clId="{9D7279F8-4830-4E52-8D06-5EEC883E0D3F}" dt="2025-09-25T10:42:31.183" v="2835" actId="1076"/>
          <ac:picMkLst>
            <pc:docMk/>
            <pc:sldMk cId="3237148080" sldId="288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31:10.342" v="2961"/>
        <pc:sldMkLst>
          <pc:docMk/>
          <pc:sldMk cId="3550454679" sldId="289"/>
        </pc:sldMkLst>
        <pc:spChg chg="add mod">
          <ac:chgData name="Ben Price" userId="64e0ee70-be78-4126-b6bb-b74f31a45510" providerId="ADAL" clId="{9D7279F8-4830-4E52-8D06-5EEC883E0D3F}" dt="2025-09-25T10:42:56.758" v="2844" actId="1076"/>
          <ac:spMkLst>
            <pc:docMk/>
            <pc:sldMk cId="3550454679" sldId="289"/>
            <ac:spMk id="2" creationId="{046BFF52-4943-5D0B-246B-0CCB0C06EC68}"/>
          </ac:spMkLst>
        </pc:spChg>
        <pc:spChg chg="mod">
          <ac:chgData name="Ben Price" userId="64e0ee70-be78-4126-b6bb-b74f31a45510" providerId="ADAL" clId="{9D7279F8-4830-4E52-8D06-5EEC883E0D3F}" dt="2025-09-18T14:42:42.035" v="2244" actId="20577"/>
          <ac:spMkLst>
            <pc:docMk/>
            <pc:sldMk cId="3550454679" sldId="289"/>
            <ac:spMk id="3" creationId="{A26699F5-1F96-5486-40A1-438AC6CE63B8}"/>
          </ac:spMkLst>
        </pc:spChg>
        <pc:spChg chg="add mod">
          <ac:chgData name="Ben Price" userId="64e0ee70-be78-4126-b6bb-b74f31a45510" providerId="ADAL" clId="{9D7279F8-4830-4E52-8D06-5EEC883E0D3F}" dt="2025-09-29T15:31:10.342" v="2961"/>
          <ac:spMkLst>
            <pc:docMk/>
            <pc:sldMk cId="3550454679" sldId="289"/>
            <ac:spMk id="4" creationId="{845C770B-A566-6D38-CA2F-9C94F8BEF4A2}"/>
          </ac:spMkLst>
        </pc:spChg>
        <pc:picChg chg="mod modCrop">
          <ac:chgData name="Ben Price" userId="64e0ee70-be78-4126-b6bb-b74f31a45510" providerId="ADAL" clId="{9D7279F8-4830-4E52-8D06-5EEC883E0D3F}" dt="2025-09-25T10:42:37.765" v="2838" actId="1076"/>
          <ac:picMkLst>
            <pc:docMk/>
            <pc:sldMk cId="3550454679" sldId="289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31:16.103" v="2962"/>
        <pc:sldMkLst>
          <pc:docMk/>
          <pc:sldMk cId="295452810" sldId="290"/>
        </pc:sldMkLst>
        <pc:spChg chg="add mod">
          <ac:chgData name="Ben Price" userId="64e0ee70-be78-4126-b6bb-b74f31a45510" providerId="ADAL" clId="{9D7279F8-4830-4E52-8D06-5EEC883E0D3F}" dt="2025-09-25T10:43:02.709" v="2846" actId="1076"/>
          <ac:spMkLst>
            <pc:docMk/>
            <pc:sldMk cId="295452810" sldId="290"/>
            <ac:spMk id="2" creationId="{CB8B33BE-35EF-CE04-BE0B-FB31B4C07AC8}"/>
          </ac:spMkLst>
        </pc:spChg>
        <pc:spChg chg="add mod">
          <ac:chgData name="Ben Price" userId="64e0ee70-be78-4126-b6bb-b74f31a45510" providerId="ADAL" clId="{9D7279F8-4830-4E52-8D06-5EEC883E0D3F}" dt="2025-09-29T15:31:16.103" v="2962"/>
          <ac:spMkLst>
            <pc:docMk/>
            <pc:sldMk cId="295452810" sldId="290"/>
            <ac:spMk id="3" creationId="{84825DEB-847D-78B6-4C7E-4C12BDB2FB23}"/>
          </ac:spMkLst>
        </pc:spChg>
        <pc:picChg chg="mod modCrop">
          <ac:chgData name="Ben Price" userId="64e0ee70-be78-4126-b6bb-b74f31a45510" providerId="ADAL" clId="{9D7279F8-4830-4E52-8D06-5EEC883E0D3F}" dt="2025-09-18T14:43:44.769" v="2253" actId="1076"/>
          <ac:picMkLst>
            <pc:docMk/>
            <pc:sldMk cId="295452810" sldId="290"/>
            <ac:picMk id="5" creationId="{A07327A7-857E-E62B-FDF2-EC76549AD207}"/>
          </ac:picMkLst>
        </pc:picChg>
      </pc:sldChg>
      <pc:sldChg chg="del">
        <pc:chgData name="Ben Price" userId="64e0ee70-be78-4126-b6bb-b74f31a45510" providerId="ADAL" clId="{9D7279F8-4830-4E52-8D06-5EEC883E0D3F}" dt="2025-09-18T13:57:13.862" v="1520" actId="47"/>
        <pc:sldMkLst>
          <pc:docMk/>
          <pc:sldMk cId="3156378891" sldId="291"/>
        </pc:sldMkLst>
      </pc:sldChg>
      <pc:sldChg chg="del">
        <pc:chgData name="Ben Price" userId="64e0ee70-be78-4126-b6bb-b74f31a45510" providerId="ADAL" clId="{9D7279F8-4830-4E52-8D06-5EEC883E0D3F}" dt="2025-09-18T13:57:01.454" v="1519" actId="47"/>
        <pc:sldMkLst>
          <pc:docMk/>
          <pc:sldMk cId="522057336" sldId="292"/>
        </pc:sldMkLst>
      </pc:sldChg>
      <pc:sldChg chg="addSp delSp modSp mod">
        <pc:chgData name="Ben Price" userId="64e0ee70-be78-4126-b6bb-b74f31a45510" providerId="ADAL" clId="{9D7279F8-4830-4E52-8D06-5EEC883E0D3F}" dt="2025-09-29T15:27:16.544" v="2932"/>
        <pc:sldMkLst>
          <pc:docMk/>
          <pc:sldMk cId="2577212698" sldId="293"/>
        </pc:sldMkLst>
        <pc:spChg chg="add mod">
          <ac:chgData name="Ben Price" userId="64e0ee70-be78-4126-b6bb-b74f31a45510" providerId="ADAL" clId="{9D7279F8-4830-4E52-8D06-5EEC883E0D3F}" dt="2025-09-25T10:44:57.849" v="2894" actId="1076"/>
          <ac:spMkLst>
            <pc:docMk/>
            <pc:sldMk cId="2577212698" sldId="293"/>
            <ac:spMk id="2" creationId="{6769A14B-DAEC-C88D-B01D-E12A5055F7B8}"/>
          </ac:spMkLst>
        </pc:spChg>
        <pc:spChg chg="add del mod">
          <ac:chgData name="Ben Price" userId="64e0ee70-be78-4126-b6bb-b74f31a45510" providerId="ADAL" clId="{9D7279F8-4830-4E52-8D06-5EEC883E0D3F}" dt="2025-09-18T14:44:33.285" v="2258" actId="1076"/>
          <ac:spMkLst>
            <pc:docMk/>
            <pc:sldMk cId="2577212698" sldId="293"/>
            <ac:spMk id="3" creationId="{4B5DEA3B-801C-4EC6-DA86-88DDEFDA0AC3}"/>
          </ac:spMkLst>
        </pc:spChg>
        <pc:spChg chg="add mod">
          <ac:chgData name="Ben Price" userId="64e0ee70-be78-4126-b6bb-b74f31a45510" providerId="ADAL" clId="{9D7279F8-4830-4E52-8D06-5EEC883E0D3F}" dt="2025-09-29T15:27:16.544" v="2932"/>
          <ac:spMkLst>
            <pc:docMk/>
            <pc:sldMk cId="2577212698" sldId="293"/>
            <ac:spMk id="4" creationId="{58C9AA8F-9A04-6FE3-D6EE-738AFDB81FB8}"/>
          </ac:spMkLst>
        </pc:spChg>
        <pc:picChg chg="mod modCrop">
          <ac:chgData name="Ben Price" userId="64e0ee70-be78-4126-b6bb-b74f31a45510" providerId="ADAL" clId="{9D7279F8-4830-4E52-8D06-5EEC883E0D3F}" dt="2025-09-25T10:44:50.856" v="2891" actId="1076"/>
          <ac:picMkLst>
            <pc:docMk/>
            <pc:sldMk cId="2577212698" sldId="293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27:21.740" v="2933"/>
        <pc:sldMkLst>
          <pc:docMk/>
          <pc:sldMk cId="4169145932" sldId="294"/>
        </pc:sldMkLst>
        <pc:spChg chg="add mod">
          <ac:chgData name="Ben Price" userId="64e0ee70-be78-4126-b6bb-b74f31a45510" providerId="ADAL" clId="{9D7279F8-4830-4E52-8D06-5EEC883E0D3F}" dt="2025-09-25T10:45:09.428" v="2898" actId="1076"/>
          <ac:spMkLst>
            <pc:docMk/>
            <pc:sldMk cId="4169145932" sldId="294"/>
            <ac:spMk id="2" creationId="{A24DB51D-A9C3-CBB9-33CF-05D31BCF8641}"/>
          </ac:spMkLst>
        </pc:spChg>
        <pc:spChg chg="add mod">
          <ac:chgData name="Ben Price" userId="64e0ee70-be78-4126-b6bb-b74f31a45510" providerId="ADAL" clId="{9D7279F8-4830-4E52-8D06-5EEC883E0D3F}" dt="2025-09-29T15:27:21.740" v="2933"/>
          <ac:spMkLst>
            <pc:docMk/>
            <pc:sldMk cId="4169145932" sldId="294"/>
            <ac:spMk id="4" creationId="{7ADF1E04-137B-9BBD-0C62-B3C3EB5D6434}"/>
          </ac:spMkLst>
        </pc:spChg>
        <pc:spChg chg="add mod">
          <ac:chgData name="Ben Price" userId="64e0ee70-be78-4126-b6bb-b74f31a45510" providerId="ADAL" clId="{9D7279F8-4830-4E52-8D06-5EEC883E0D3F}" dt="2025-09-18T14:47:13.254" v="2264" actId="1076"/>
          <ac:spMkLst>
            <pc:docMk/>
            <pc:sldMk cId="4169145932" sldId="294"/>
            <ac:spMk id="6" creationId="{D7FA89E1-C8A0-E8F3-C08E-A910031F81D0}"/>
          </ac:spMkLst>
        </pc:spChg>
        <pc:picChg chg="mod modCrop">
          <ac:chgData name="Ben Price" userId="64e0ee70-be78-4126-b6bb-b74f31a45510" providerId="ADAL" clId="{9D7279F8-4830-4E52-8D06-5EEC883E0D3F}" dt="2025-09-25T10:45:03.278" v="2895" actId="1076"/>
          <ac:picMkLst>
            <pc:docMk/>
            <pc:sldMk cId="4169145932" sldId="294"/>
            <ac:picMk id="5" creationId="{A07327A7-857E-E62B-FDF2-EC76549AD207}"/>
          </ac:picMkLst>
        </pc:picChg>
      </pc:sldChg>
      <pc:sldChg chg="del">
        <pc:chgData name="Ben Price" userId="64e0ee70-be78-4126-b6bb-b74f31a45510" providerId="ADAL" clId="{9D7279F8-4830-4E52-8D06-5EEC883E0D3F}" dt="2025-09-18T13:58:30.309" v="1527" actId="47"/>
        <pc:sldMkLst>
          <pc:docMk/>
          <pc:sldMk cId="1107607044" sldId="295"/>
        </pc:sldMkLst>
      </pc:sldChg>
      <pc:sldChg chg="addSp delSp modSp mod">
        <pc:chgData name="Ben Price" userId="64e0ee70-be78-4126-b6bb-b74f31a45510" providerId="ADAL" clId="{9D7279F8-4830-4E52-8D06-5EEC883E0D3F}" dt="2025-09-29T15:27:33.664" v="2934"/>
        <pc:sldMkLst>
          <pc:docMk/>
          <pc:sldMk cId="2479035802" sldId="296"/>
        </pc:sldMkLst>
        <pc:spChg chg="add mod">
          <ac:chgData name="Ben Price" userId="64e0ee70-be78-4126-b6bb-b74f31a45510" providerId="ADAL" clId="{9D7279F8-4830-4E52-8D06-5EEC883E0D3F}" dt="2025-09-25T10:45:17.760" v="2900" actId="1076"/>
          <ac:spMkLst>
            <pc:docMk/>
            <pc:sldMk cId="2479035802" sldId="296"/>
            <ac:spMk id="2" creationId="{E5F2CDFC-1E8D-A101-7270-4A932B31BD76}"/>
          </ac:spMkLst>
        </pc:spChg>
        <pc:spChg chg="mod">
          <ac:chgData name="Ben Price" userId="64e0ee70-be78-4126-b6bb-b74f31a45510" providerId="ADAL" clId="{9D7279F8-4830-4E52-8D06-5EEC883E0D3F}" dt="2025-09-18T14:48:13.013" v="2272" actId="1076"/>
          <ac:spMkLst>
            <pc:docMk/>
            <pc:sldMk cId="2479035802" sldId="296"/>
            <ac:spMk id="3" creationId="{4B5DEA3B-801C-4EC6-DA86-88DDEFDA0AC3}"/>
          </ac:spMkLst>
        </pc:spChg>
        <pc:spChg chg="add mod">
          <ac:chgData name="Ben Price" userId="64e0ee70-be78-4126-b6bb-b74f31a45510" providerId="ADAL" clId="{9D7279F8-4830-4E52-8D06-5EEC883E0D3F}" dt="2025-09-29T15:27:33.664" v="2934"/>
          <ac:spMkLst>
            <pc:docMk/>
            <pc:sldMk cId="2479035802" sldId="296"/>
            <ac:spMk id="4" creationId="{2C573873-0361-B3AD-4089-D394C9DB24C6}"/>
          </ac:spMkLst>
        </pc:spChg>
        <pc:picChg chg="mod modCrop">
          <ac:chgData name="Ben Price" userId="64e0ee70-be78-4126-b6bb-b74f31a45510" providerId="ADAL" clId="{9D7279F8-4830-4E52-8D06-5EEC883E0D3F}" dt="2025-09-18T14:48:07.585" v="2271" actId="14100"/>
          <ac:picMkLst>
            <pc:docMk/>
            <pc:sldMk cId="2479035802" sldId="296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27:42.713" v="2935"/>
        <pc:sldMkLst>
          <pc:docMk/>
          <pc:sldMk cId="3282927684" sldId="297"/>
        </pc:sldMkLst>
        <pc:spChg chg="add mod">
          <ac:chgData name="Ben Price" userId="64e0ee70-be78-4126-b6bb-b74f31a45510" providerId="ADAL" clId="{9D7279F8-4830-4E52-8D06-5EEC883E0D3F}" dt="2025-09-25T10:45:24.865" v="2903" actId="1076"/>
          <ac:spMkLst>
            <pc:docMk/>
            <pc:sldMk cId="3282927684" sldId="297"/>
            <ac:spMk id="2" creationId="{2B9DCE6F-7663-D097-E54A-00CBA4FFE64A}"/>
          </ac:spMkLst>
        </pc:spChg>
        <pc:spChg chg="add mod">
          <ac:chgData name="Ben Price" userId="64e0ee70-be78-4126-b6bb-b74f31a45510" providerId="ADAL" clId="{9D7279F8-4830-4E52-8D06-5EEC883E0D3F}" dt="2025-09-29T15:27:42.713" v="2935"/>
          <ac:spMkLst>
            <pc:docMk/>
            <pc:sldMk cId="3282927684" sldId="297"/>
            <ac:spMk id="3" creationId="{19C9726B-78BC-5BBD-527E-A5F02F6FDE00}"/>
          </ac:spMkLst>
        </pc:spChg>
        <pc:spChg chg="mod">
          <ac:chgData name="Ben Price" userId="64e0ee70-be78-4126-b6bb-b74f31a45510" providerId="ADAL" clId="{9D7279F8-4830-4E52-8D06-5EEC883E0D3F}" dt="2025-09-18T14:49:13.790" v="2282" actId="1076"/>
          <ac:spMkLst>
            <pc:docMk/>
            <pc:sldMk cId="3282927684" sldId="297"/>
            <ac:spMk id="4" creationId="{4362D523-CDD9-158C-6F0B-EB11429A3B40}"/>
          </ac:spMkLst>
        </pc:spChg>
        <pc:picChg chg="mod modCrop">
          <ac:chgData name="Ben Price" userId="64e0ee70-be78-4126-b6bb-b74f31a45510" providerId="ADAL" clId="{9D7279F8-4830-4E52-8D06-5EEC883E0D3F}" dt="2025-09-25T10:45:21.238" v="2901" actId="1076"/>
          <ac:picMkLst>
            <pc:docMk/>
            <pc:sldMk cId="3282927684" sldId="297"/>
            <ac:picMk id="5" creationId="{A07327A7-857E-E62B-FDF2-EC76549AD207}"/>
          </ac:picMkLst>
        </pc:picChg>
      </pc:sldChg>
      <pc:sldChg chg="del">
        <pc:chgData name="Ben Price" userId="64e0ee70-be78-4126-b6bb-b74f31a45510" providerId="ADAL" clId="{9D7279F8-4830-4E52-8D06-5EEC883E0D3F}" dt="2025-09-18T13:57:22.869" v="1521" actId="47"/>
        <pc:sldMkLst>
          <pc:docMk/>
          <pc:sldMk cId="4013433880" sldId="298"/>
        </pc:sldMkLst>
      </pc:sldChg>
      <pc:sldChg chg="del">
        <pc:chgData name="Ben Price" userId="64e0ee70-be78-4126-b6bb-b74f31a45510" providerId="ADAL" clId="{9D7279F8-4830-4E52-8D06-5EEC883E0D3F}" dt="2025-09-18T13:57:26.928" v="1522" actId="47"/>
        <pc:sldMkLst>
          <pc:docMk/>
          <pc:sldMk cId="1236230890" sldId="299"/>
        </pc:sldMkLst>
      </pc:sldChg>
      <pc:sldChg chg="addSp delSp modSp mod">
        <pc:chgData name="Ben Price" userId="64e0ee70-be78-4126-b6bb-b74f31a45510" providerId="ADAL" clId="{9D7279F8-4830-4E52-8D06-5EEC883E0D3F}" dt="2025-09-29T15:27:46.489" v="2936"/>
        <pc:sldMkLst>
          <pc:docMk/>
          <pc:sldMk cId="1199786667" sldId="300"/>
        </pc:sldMkLst>
        <pc:spChg chg="add mod">
          <ac:chgData name="Ben Price" userId="64e0ee70-be78-4126-b6bb-b74f31a45510" providerId="ADAL" clId="{9D7279F8-4830-4E52-8D06-5EEC883E0D3F}" dt="2025-09-25T10:46:20.360" v="2917" actId="1076"/>
          <ac:spMkLst>
            <pc:docMk/>
            <pc:sldMk cId="1199786667" sldId="300"/>
            <ac:spMk id="2" creationId="{6E8AD943-F1DA-F789-94E4-33D738F3CA4D}"/>
          </ac:spMkLst>
        </pc:spChg>
        <pc:spChg chg="mod">
          <ac:chgData name="Ben Price" userId="64e0ee70-be78-4126-b6bb-b74f31a45510" providerId="ADAL" clId="{9D7279F8-4830-4E52-8D06-5EEC883E0D3F}" dt="2025-09-18T14:49:43.949" v="2287" actId="1076"/>
          <ac:spMkLst>
            <pc:docMk/>
            <pc:sldMk cId="1199786667" sldId="300"/>
            <ac:spMk id="3" creationId="{4B5DEA3B-801C-4EC6-DA86-88DDEFDA0AC3}"/>
          </ac:spMkLst>
        </pc:spChg>
        <pc:spChg chg="add mod">
          <ac:chgData name="Ben Price" userId="64e0ee70-be78-4126-b6bb-b74f31a45510" providerId="ADAL" clId="{9D7279F8-4830-4E52-8D06-5EEC883E0D3F}" dt="2025-09-29T15:27:46.489" v="2936"/>
          <ac:spMkLst>
            <pc:docMk/>
            <pc:sldMk cId="1199786667" sldId="300"/>
            <ac:spMk id="6" creationId="{51597F63-DAA5-20E0-2805-6F7CE8CFEE87}"/>
          </ac:spMkLst>
        </pc:spChg>
        <pc:picChg chg="mod modCrop">
          <ac:chgData name="Ben Price" userId="64e0ee70-be78-4126-b6bb-b74f31a45510" providerId="ADAL" clId="{9D7279F8-4830-4E52-8D06-5EEC883E0D3F}" dt="2025-09-25T10:45:39.334" v="2906" actId="1076"/>
          <ac:picMkLst>
            <pc:docMk/>
            <pc:sldMk cId="1199786667" sldId="300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27:51.304" v="2937"/>
        <pc:sldMkLst>
          <pc:docMk/>
          <pc:sldMk cId="4094943068" sldId="301"/>
        </pc:sldMkLst>
        <pc:spChg chg="add mod">
          <ac:chgData name="Ben Price" userId="64e0ee70-be78-4126-b6bb-b74f31a45510" providerId="ADAL" clId="{9D7279F8-4830-4E52-8D06-5EEC883E0D3F}" dt="2025-09-18T14:51:29.184" v="2320" actId="1076"/>
          <ac:spMkLst>
            <pc:docMk/>
            <pc:sldMk cId="4094943068" sldId="301"/>
            <ac:spMk id="2" creationId="{A56FB69C-D43A-2583-7337-AE0A85BD98DA}"/>
          </ac:spMkLst>
        </pc:spChg>
        <pc:spChg chg="add mod">
          <ac:chgData name="Ben Price" userId="64e0ee70-be78-4126-b6bb-b74f31a45510" providerId="ADAL" clId="{9D7279F8-4830-4E52-8D06-5EEC883E0D3F}" dt="2025-09-29T15:27:51.304" v="2937"/>
          <ac:spMkLst>
            <pc:docMk/>
            <pc:sldMk cId="4094943068" sldId="301"/>
            <ac:spMk id="3" creationId="{F9079FC7-22F3-0BE3-EA65-AED93C189621}"/>
          </ac:spMkLst>
        </pc:spChg>
        <pc:spChg chg="add mod">
          <ac:chgData name="Ben Price" userId="64e0ee70-be78-4126-b6bb-b74f31a45510" providerId="ADAL" clId="{9D7279F8-4830-4E52-8D06-5EEC883E0D3F}" dt="2025-09-25T10:46:11.031" v="2914" actId="1076"/>
          <ac:spMkLst>
            <pc:docMk/>
            <pc:sldMk cId="4094943068" sldId="301"/>
            <ac:spMk id="4" creationId="{14843DFE-E66A-E0F2-AC01-2D6977BC619E}"/>
          </ac:spMkLst>
        </pc:spChg>
        <pc:picChg chg="mod modCrop">
          <ac:chgData name="Ben Price" userId="64e0ee70-be78-4126-b6bb-b74f31a45510" providerId="ADAL" clId="{9D7279F8-4830-4E52-8D06-5EEC883E0D3F}" dt="2025-09-25T10:45:59.053" v="2910" actId="1076"/>
          <ac:picMkLst>
            <pc:docMk/>
            <pc:sldMk cId="4094943068" sldId="301"/>
            <ac:picMk id="5" creationId="{A07327A7-857E-E62B-FDF2-EC76549AD207}"/>
          </ac:picMkLst>
        </pc:picChg>
      </pc:sldChg>
      <pc:sldChg chg="del">
        <pc:chgData name="Ben Price" userId="64e0ee70-be78-4126-b6bb-b74f31a45510" providerId="ADAL" clId="{9D7279F8-4830-4E52-8D06-5EEC883E0D3F}" dt="2025-09-18T13:57:35.692" v="1523" actId="47"/>
        <pc:sldMkLst>
          <pc:docMk/>
          <pc:sldMk cId="1521589475" sldId="302"/>
        </pc:sldMkLst>
      </pc:sldChg>
      <pc:sldChg chg="del">
        <pc:chgData name="Ben Price" userId="64e0ee70-be78-4126-b6bb-b74f31a45510" providerId="ADAL" clId="{9D7279F8-4830-4E52-8D06-5EEC883E0D3F}" dt="2025-09-18T13:57:36.351" v="1524" actId="47"/>
        <pc:sldMkLst>
          <pc:docMk/>
          <pc:sldMk cId="2047555123" sldId="303"/>
        </pc:sldMkLst>
      </pc:sldChg>
      <pc:sldChg chg="addSp delSp modSp mod">
        <pc:chgData name="Ben Price" userId="64e0ee70-be78-4126-b6bb-b74f31a45510" providerId="ADAL" clId="{9D7279F8-4830-4E52-8D06-5EEC883E0D3F}" dt="2025-09-29T15:27:54.927" v="2938"/>
        <pc:sldMkLst>
          <pc:docMk/>
          <pc:sldMk cId="2493529578" sldId="304"/>
        </pc:sldMkLst>
        <pc:spChg chg="add mod">
          <ac:chgData name="Ben Price" userId="64e0ee70-be78-4126-b6bb-b74f31a45510" providerId="ADAL" clId="{9D7279F8-4830-4E52-8D06-5EEC883E0D3F}" dt="2025-09-25T10:46:30.475" v="2919" actId="1076"/>
          <ac:spMkLst>
            <pc:docMk/>
            <pc:sldMk cId="2493529578" sldId="304"/>
            <ac:spMk id="2" creationId="{EFAAE373-5A1D-4667-D760-5BB912B6AA64}"/>
          </ac:spMkLst>
        </pc:spChg>
        <pc:spChg chg="mod">
          <ac:chgData name="Ben Price" userId="64e0ee70-be78-4126-b6bb-b74f31a45510" providerId="ADAL" clId="{9D7279F8-4830-4E52-8D06-5EEC883E0D3F}" dt="2025-09-18T14:52:24.692" v="2334" actId="1076"/>
          <ac:spMkLst>
            <pc:docMk/>
            <pc:sldMk cId="2493529578" sldId="304"/>
            <ac:spMk id="3" creationId="{4B5DEA3B-801C-4EC6-DA86-88DDEFDA0AC3}"/>
          </ac:spMkLst>
        </pc:spChg>
        <pc:spChg chg="add mod">
          <ac:chgData name="Ben Price" userId="64e0ee70-be78-4126-b6bb-b74f31a45510" providerId="ADAL" clId="{9D7279F8-4830-4E52-8D06-5EEC883E0D3F}" dt="2025-09-29T15:27:54.927" v="2938"/>
          <ac:spMkLst>
            <pc:docMk/>
            <pc:sldMk cId="2493529578" sldId="304"/>
            <ac:spMk id="4" creationId="{566C57D9-8F8E-33C1-0FB3-E69925660EEC}"/>
          </ac:spMkLst>
        </pc:spChg>
        <pc:picChg chg="mod modCrop">
          <ac:chgData name="Ben Price" userId="64e0ee70-be78-4126-b6bb-b74f31a45510" providerId="ADAL" clId="{9D7279F8-4830-4E52-8D06-5EEC883E0D3F}" dt="2025-09-18T14:52:21.269" v="2333" actId="1076"/>
          <ac:picMkLst>
            <pc:docMk/>
            <pc:sldMk cId="2493529578" sldId="304"/>
            <ac:picMk id="5" creationId="{A07327A7-857E-E62B-FDF2-EC76549AD207}"/>
          </ac:picMkLst>
        </pc:picChg>
      </pc:sldChg>
      <pc:sldChg chg="addSp delSp modSp mod">
        <pc:chgData name="Ben Price" userId="64e0ee70-be78-4126-b6bb-b74f31a45510" providerId="ADAL" clId="{9D7279F8-4830-4E52-8D06-5EEC883E0D3F}" dt="2025-09-29T15:28:00.147" v="2939"/>
        <pc:sldMkLst>
          <pc:docMk/>
          <pc:sldMk cId="878087411" sldId="305"/>
        </pc:sldMkLst>
        <pc:spChg chg="add mod">
          <ac:chgData name="Ben Price" userId="64e0ee70-be78-4126-b6bb-b74f31a45510" providerId="ADAL" clId="{9D7279F8-4830-4E52-8D06-5EEC883E0D3F}" dt="2025-09-25T10:46:39.295" v="2923" actId="1076"/>
          <ac:spMkLst>
            <pc:docMk/>
            <pc:sldMk cId="878087411" sldId="305"/>
            <ac:spMk id="2" creationId="{86D9C795-479E-6520-6310-53114960C72E}"/>
          </ac:spMkLst>
        </pc:spChg>
        <pc:spChg chg="add mod">
          <ac:chgData name="Ben Price" userId="64e0ee70-be78-4126-b6bb-b74f31a45510" providerId="ADAL" clId="{9D7279F8-4830-4E52-8D06-5EEC883E0D3F}" dt="2025-09-29T15:28:00.147" v="2939"/>
          <ac:spMkLst>
            <pc:docMk/>
            <pc:sldMk cId="878087411" sldId="305"/>
            <ac:spMk id="3" creationId="{8D081B3E-6928-516C-F45F-4AC41EF30860}"/>
          </ac:spMkLst>
        </pc:spChg>
        <pc:spChg chg="mod">
          <ac:chgData name="Ben Price" userId="64e0ee70-be78-4126-b6bb-b74f31a45510" providerId="ADAL" clId="{9D7279F8-4830-4E52-8D06-5EEC883E0D3F}" dt="2025-09-18T14:53:29.563" v="2351" actId="20577"/>
          <ac:spMkLst>
            <pc:docMk/>
            <pc:sldMk cId="878087411" sldId="305"/>
            <ac:spMk id="4" creationId="{4362D523-CDD9-158C-6F0B-EB11429A3B40}"/>
          </ac:spMkLst>
        </pc:spChg>
        <pc:picChg chg="mod modCrop">
          <ac:chgData name="Ben Price" userId="64e0ee70-be78-4126-b6bb-b74f31a45510" providerId="ADAL" clId="{9D7279F8-4830-4E52-8D06-5EEC883E0D3F}" dt="2025-09-25T10:46:34.324" v="2921" actId="1076"/>
          <ac:picMkLst>
            <pc:docMk/>
            <pc:sldMk cId="878087411" sldId="305"/>
            <ac:picMk id="5" creationId="{A07327A7-857E-E62B-FDF2-EC76549AD207}"/>
          </ac:picMkLst>
        </pc:picChg>
      </pc:sldChg>
      <pc:sldChg chg="del">
        <pc:chgData name="Ben Price" userId="64e0ee70-be78-4126-b6bb-b74f31a45510" providerId="ADAL" clId="{9D7279F8-4830-4E52-8D06-5EEC883E0D3F}" dt="2025-09-18T13:57:43.528" v="1525" actId="47"/>
        <pc:sldMkLst>
          <pc:docMk/>
          <pc:sldMk cId="3697544981" sldId="306"/>
        </pc:sldMkLst>
      </pc:sldChg>
      <pc:sldChg chg="del">
        <pc:chgData name="Ben Price" userId="64e0ee70-be78-4126-b6bb-b74f31a45510" providerId="ADAL" clId="{9D7279F8-4830-4E52-8D06-5EEC883E0D3F}" dt="2025-09-18T13:57:45.806" v="1526" actId="47"/>
        <pc:sldMkLst>
          <pc:docMk/>
          <pc:sldMk cId="3842065677" sldId="307"/>
        </pc:sldMkLst>
      </pc:sldChg>
      <pc:sldChg chg="addSp delSp modSp mod">
        <pc:chgData name="Ben Price" userId="64e0ee70-be78-4126-b6bb-b74f31a45510" providerId="ADAL" clId="{9D7279F8-4830-4E52-8D06-5EEC883E0D3F}" dt="2025-09-29T15:31:32.212" v="2963"/>
        <pc:sldMkLst>
          <pc:docMk/>
          <pc:sldMk cId="1801483572" sldId="308"/>
        </pc:sldMkLst>
        <pc:spChg chg="add mod">
          <ac:chgData name="Ben Price" userId="64e0ee70-be78-4126-b6bb-b74f31a45510" providerId="ADAL" clId="{9D7279F8-4830-4E52-8D06-5EEC883E0D3F}" dt="2025-09-25T10:43:24.506" v="2850" actId="1076"/>
          <ac:spMkLst>
            <pc:docMk/>
            <pc:sldMk cId="1801483572" sldId="308"/>
            <ac:spMk id="2" creationId="{FEB2E0DD-7BA1-0F9D-24BC-883CA88B62B5}"/>
          </ac:spMkLst>
        </pc:spChg>
        <pc:spChg chg="mod">
          <ac:chgData name="Ben Price" userId="64e0ee70-be78-4126-b6bb-b74f31a45510" providerId="ADAL" clId="{9D7279F8-4830-4E52-8D06-5EEC883E0D3F}" dt="2025-09-18T14:54:33.485" v="2360" actId="1076"/>
          <ac:spMkLst>
            <pc:docMk/>
            <pc:sldMk cId="1801483572" sldId="308"/>
            <ac:spMk id="3" creationId="{4B5DEA3B-801C-4EC6-DA86-88DDEFDA0AC3}"/>
          </ac:spMkLst>
        </pc:spChg>
        <pc:spChg chg="add mod">
          <ac:chgData name="Ben Price" userId="64e0ee70-be78-4126-b6bb-b74f31a45510" providerId="ADAL" clId="{9D7279F8-4830-4E52-8D06-5EEC883E0D3F}" dt="2025-09-29T15:31:32.212" v="2963"/>
          <ac:spMkLst>
            <pc:docMk/>
            <pc:sldMk cId="1801483572" sldId="308"/>
            <ac:spMk id="4" creationId="{68B35D42-3CB5-6947-C124-550199C9783E}"/>
          </ac:spMkLst>
        </pc:spChg>
        <pc:picChg chg="mod modCrop">
          <ac:chgData name="Ben Price" userId="64e0ee70-be78-4126-b6bb-b74f31a45510" providerId="ADAL" clId="{9D7279F8-4830-4E52-8D06-5EEC883E0D3F}" dt="2025-09-25T10:43:17.434" v="2848" actId="1076"/>
          <ac:picMkLst>
            <pc:docMk/>
            <pc:sldMk cId="1801483572" sldId="308"/>
            <ac:picMk id="5" creationId="{A07327A7-857E-E62B-FDF2-EC76549AD207}"/>
          </ac:picMkLst>
        </pc:picChg>
      </pc:sldChg>
      <pc:sldChg chg="addSp delSp modSp add del mod">
        <pc:chgData name="Ben Price" userId="64e0ee70-be78-4126-b6bb-b74f31a45510" providerId="ADAL" clId="{9D7279F8-4830-4E52-8D06-5EEC883E0D3F}" dt="2025-09-18T14:23:07.865" v="2035" actId="47"/>
        <pc:sldMkLst>
          <pc:docMk/>
          <pc:sldMk cId="1333362942" sldId="309"/>
        </pc:sldMkLst>
      </pc:sldChg>
      <pc:sldChg chg="new del">
        <pc:chgData name="Ben Price" userId="64e0ee70-be78-4126-b6bb-b74f31a45510" providerId="ADAL" clId="{9D7279F8-4830-4E52-8D06-5EEC883E0D3F}" dt="2025-09-18T12:51:10.949" v="635" actId="47"/>
        <pc:sldMkLst>
          <pc:docMk/>
          <pc:sldMk cId="4178713059" sldId="309"/>
        </pc:sldMkLst>
      </pc:sldChg>
    </pc:docChg>
  </pc:docChgLst>
  <pc:docChgLst>
    <pc:chgData name="Ben Price" userId="64e0ee70-be78-4126-b6bb-b74f31a45510" providerId="ADAL" clId="{18A030CA-30BC-4F94-8432-9115970381F7}"/>
    <pc:docChg chg="custSel addSld delSld modSld sldOrd">
      <pc:chgData name="Ben Price" userId="64e0ee70-be78-4126-b6bb-b74f31a45510" providerId="ADAL" clId="{18A030CA-30BC-4F94-8432-9115970381F7}" dt="2025-06-16T16:34:11.526" v="867" actId="14826"/>
      <pc:docMkLst>
        <pc:docMk/>
      </pc:docMkLst>
      <pc:sldChg chg="add del">
        <pc:chgData name="Ben Price" userId="64e0ee70-be78-4126-b6bb-b74f31a45510" providerId="ADAL" clId="{18A030CA-30BC-4F94-8432-9115970381F7}" dt="2025-06-16T14:16:06.970" v="1" actId="47"/>
        <pc:sldMkLst>
          <pc:docMk/>
          <pc:sldMk cId="371618359" sldId="266"/>
        </pc:sldMkLst>
      </pc:sldChg>
      <pc:sldChg chg="modSp add mod ord">
        <pc:chgData name="Ben Price" userId="64e0ee70-be78-4126-b6bb-b74f31a45510" providerId="ADAL" clId="{18A030CA-30BC-4F94-8432-9115970381F7}" dt="2025-06-16T14:16:37.737" v="20" actId="14826"/>
        <pc:sldMkLst>
          <pc:docMk/>
          <pc:sldMk cId="2927916576" sldId="266"/>
        </pc:sldMkLst>
      </pc:sldChg>
      <pc:sldChg chg="addSp modSp add mod">
        <pc:chgData name="Ben Price" userId="64e0ee70-be78-4126-b6bb-b74f31a45510" providerId="ADAL" clId="{18A030CA-30BC-4F94-8432-9115970381F7}" dt="2025-06-16T14:24:28.343" v="118" actId="14826"/>
        <pc:sldMkLst>
          <pc:docMk/>
          <pc:sldMk cId="801077105" sldId="267"/>
        </pc:sldMkLst>
      </pc:sldChg>
      <pc:sldChg chg="new del">
        <pc:chgData name="Ben Price" userId="64e0ee70-be78-4126-b6bb-b74f31a45510" providerId="ADAL" clId="{18A030CA-30BC-4F94-8432-9115970381F7}" dt="2025-06-16T14:19:08.108" v="42" actId="47"/>
        <pc:sldMkLst>
          <pc:docMk/>
          <pc:sldMk cId="2792267330" sldId="267"/>
        </pc:sldMkLst>
      </pc:sldChg>
      <pc:sldChg chg="modSp add del mod">
        <pc:chgData name="Ben Price" userId="64e0ee70-be78-4126-b6bb-b74f31a45510" providerId="ADAL" clId="{18A030CA-30BC-4F94-8432-9115970381F7}" dt="2025-06-16T14:18:57.442" v="40" actId="47"/>
        <pc:sldMkLst>
          <pc:docMk/>
          <pc:sldMk cId="3807566478" sldId="267"/>
        </pc:sldMkLst>
      </pc:sldChg>
      <pc:sldChg chg="addSp delSp modSp add mod">
        <pc:chgData name="Ben Price" userId="64e0ee70-be78-4126-b6bb-b74f31a45510" providerId="ADAL" clId="{18A030CA-30BC-4F94-8432-9115970381F7}" dt="2025-06-16T14:25:22.976" v="127" actId="20577"/>
        <pc:sldMkLst>
          <pc:docMk/>
          <pc:sldMk cId="2168095722" sldId="268"/>
        </pc:sldMkLst>
      </pc:sldChg>
      <pc:sldChg chg="modSp add mod ord">
        <pc:chgData name="Ben Price" userId="64e0ee70-be78-4126-b6bb-b74f31a45510" providerId="ADAL" clId="{18A030CA-30BC-4F94-8432-9115970381F7}" dt="2025-06-16T14:25:58.938" v="150" actId="14826"/>
        <pc:sldMkLst>
          <pc:docMk/>
          <pc:sldMk cId="3593437801" sldId="269"/>
        </pc:sldMkLst>
      </pc:sldChg>
      <pc:sldChg chg="modSp add mod">
        <pc:chgData name="Ben Price" userId="64e0ee70-be78-4126-b6bb-b74f31a45510" providerId="ADAL" clId="{18A030CA-30BC-4F94-8432-9115970381F7}" dt="2025-06-16T14:26:34.743" v="171" actId="14826"/>
        <pc:sldMkLst>
          <pc:docMk/>
          <pc:sldMk cId="756201150" sldId="270"/>
        </pc:sldMkLst>
      </pc:sldChg>
      <pc:sldChg chg="add del">
        <pc:chgData name="Ben Price" userId="64e0ee70-be78-4126-b6bb-b74f31a45510" providerId="ADAL" clId="{18A030CA-30BC-4F94-8432-9115970381F7}" dt="2025-06-16T14:27:23.408" v="176" actId="47"/>
        <pc:sldMkLst>
          <pc:docMk/>
          <pc:sldMk cId="3735648711" sldId="271"/>
        </pc:sldMkLst>
      </pc:sldChg>
      <pc:sldChg chg="modSp add mod ord">
        <pc:chgData name="Ben Price" userId="64e0ee70-be78-4126-b6bb-b74f31a45510" providerId="ADAL" clId="{18A030CA-30BC-4F94-8432-9115970381F7}" dt="2025-06-16T14:27:53.015" v="184" actId="14826"/>
        <pc:sldMkLst>
          <pc:docMk/>
          <pc:sldMk cId="1397535773" sldId="272"/>
        </pc:sldMkLst>
      </pc:sldChg>
      <pc:sldChg chg="modSp add mod ord">
        <pc:chgData name="Ben Price" userId="64e0ee70-be78-4126-b6bb-b74f31a45510" providerId="ADAL" clId="{18A030CA-30BC-4F94-8432-9115970381F7}" dt="2025-06-16T14:29:15.729" v="203" actId="14826"/>
        <pc:sldMkLst>
          <pc:docMk/>
          <pc:sldMk cId="600024648" sldId="273"/>
        </pc:sldMkLst>
      </pc:sldChg>
      <pc:sldChg chg="modSp add mod">
        <pc:chgData name="Ben Price" userId="64e0ee70-be78-4126-b6bb-b74f31a45510" providerId="ADAL" clId="{18A030CA-30BC-4F94-8432-9115970381F7}" dt="2025-06-16T14:30:20.800" v="222" actId="14826"/>
        <pc:sldMkLst>
          <pc:docMk/>
          <pc:sldMk cId="2276253020" sldId="274"/>
        </pc:sldMkLst>
      </pc:sldChg>
      <pc:sldChg chg="modSp add mod ord">
        <pc:chgData name="Ben Price" userId="64e0ee70-be78-4126-b6bb-b74f31a45510" providerId="ADAL" clId="{18A030CA-30BC-4F94-8432-9115970381F7}" dt="2025-06-16T14:31:48.973" v="233" actId="14826"/>
        <pc:sldMkLst>
          <pc:docMk/>
          <pc:sldMk cId="3738433072" sldId="275"/>
        </pc:sldMkLst>
      </pc:sldChg>
      <pc:sldChg chg="add del ord">
        <pc:chgData name="Ben Price" userId="64e0ee70-be78-4126-b6bb-b74f31a45510" providerId="ADAL" clId="{18A030CA-30BC-4F94-8432-9115970381F7}" dt="2025-06-16T14:32:32.934" v="237" actId="47"/>
        <pc:sldMkLst>
          <pc:docMk/>
          <pc:sldMk cId="3292139164" sldId="276"/>
        </pc:sldMkLst>
      </pc:sldChg>
      <pc:sldChg chg="modSp add mod ord">
        <pc:chgData name="Ben Price" userId="64e0ee70-be78-4126-b6bb-b74f31a45510" providerId="ADAL" clId="{18A030CA-30BC-4F94-8432-9115970381F7}" dt="2025-06-16T16:02:08.308" v="248" actId="14826"/>
        <pc:sldMkLst>
          <pc:docMk/>
          <pc:sldMk cId="3678121570" sldId="276"/>
        </pc:sldMkLst>
      </pc:sldChg>
      <pc:sldChg chg="modSp add mod ord">
        <pc:chgData name="Ben Price" userId="64e0ee70-be78-4126-b6bb-b74f31a45510" providerId="ADAL" clId="{18A030CA-30BC-4F94-8432-9115970381F7}" dt="2025-06-16T16:09:18.296" v="262" actId="14826"/>
        <pc:sldMkLst>
          <pc:docMk/>
          <pc:sldMk cId="3012135928" sldId="277"/>
        </pc:sldMkLst>
      </pc:sldChg>
      <pc:sldChg chg="modSp add mod">
        <pc:chgData name="Ben Price" userId="64e0ee70-be78-4126-b6bb-b74f31a45510" providerId="ADAL" clId="{18A030CA-30BC-4F94-8432-9115970381F7}" dt="2025-06-16T16:09:36.533" v="281" actId="14826"/>
        <pc:sldMkLst>
          <pc:docMk/>
          <pc:sldMk cId="2559390613" sldId="278"/>
        </pc:sldMkLst>
      </pc:sldChg>
      <pc:sldChg chg="modSp add mod ord">
        <pc:chgData name="Ben Price" userId="64e0ee70-be78-4126-b6bb-b74f31a45510" providerId="ADAL" clId="{18A030CA-30BC-4F94-8432-9115970381F7}" dt="2025-06-16T16:10:20.947" v="297" actId="14826"/>
        <pc:sldMkLst>
          <pc:docMk/>
          <pc:sldMk cId="2629514977" sldId="279"/>
        </pc:sldMkLst>
      </pc:sldChg>
      <pc:sldChg chg="modSp add mod ord">
        <pc:chgData name="Ben Price" userId="64e0ee70-be78-4126-b6bb-b74f31a45510" providerId="ADAL" clId="{18A030CA-30BC-4F94-8432-9115970381F7}" dt="2025-06-16T16:10:44.510" v="311" actId="14826"/>
        <pc:sldMkLst>
          <pc:docMk/>
          <pc:sldMk cId="809103216" sldId="280"/>
        </pc:sldMkLst>
      </pc:sldChg>
      <pc:sldChg chg="modSp add mod">
        <pc:chgData name="Ben Price" userId="64e0ee70-be78-4126-b6bb-b74f31a45510" providerId="ADAL" clId="{18A030CA-30BC-4F94-8432-9115970381F7}" dt="2025-06-16T16:11:14.165" v="338" actId="14826"/>
        <pc:sldMkLst>
          <pc:docMk/>
          <pc:sldMk cId="2086721289" sldId="281"/>
        </pc:sldMkLst>
      </pc:sldChg>
      <pc:sldChg chg="modSp add mod ord">
        <pc:chgData name="Ben Price" userId="64e0ee70-be78-4126-b6bb-b74f31a45510" providerId="ADAL" clId="{18A030CA-30BC-4F94-8432-9115970381F7}" dt="2025-06-16T16:11:45.800" v="352" actId="14826"/>
        <pc:sldMkLst>
          <pc:docMk/>
          <pc:sldMk cId="1612584656" sldId="282"/>
        </pc:sldMkLst>
      </pc:sldChg>
      <pc:sldChg chg="modSp add del mod">
        <pc:chgData name="Ben Price" userId="64e0ee70-be78-4126-b6bb-b74f31a45510" providerId="ADAL" clId="{18A030CA-30BC-4F94-8432-9115970381F7}" dt="2025-06-16T16:14:06.617" v="437" actId="47"/>
        <pc:sldMkLst>
          <pc:docMk/>
          <pc:sldMk cId="2081605074" sldId="283"/>
        </pc:sldMkLst>
      </pc:sldChg>
      <pc:sldChg chg="modSp add mod ord">
        <pc:chgData name="Ben Price" userId="64e0ee70-be78-4126-b6bb-b74f31a45510" providerId="ADAL" clId="{18A030CA-30BC-4F94-8432-9115970381F7}" dt="2025-06-16T16:12:45.911" v="397" actId="14826"/>
        <pc:sldMkLst>
          <pc:docMk/>
          <pc:sldMk cId="305824627" sldId="284"/>
        </pc:sldMkLst>
      </pc:sldChg>
      <pc:sldChg chg="modSp add mod ord">
        <pc:chgData name="Ben Price" userId="64e0ee70-be78-4126-b6bb-b74f31a45510" providerId="ADAL" clId="{18A030CA-30BC-4F94-8432-9115970381F7}" dt="2025-06-16T16:13:30.734" v="416" actId="14826"/>
        <pc:sldMkLst>
          <pc:docMk/>
          <pc:sldMk cId="3931762510" sldId="285"/>
        </pc:sldMkLst>
      </pc:sldChg>
      <pc:sldChg chg="modSp add mod ord">
        <pc:chgData name="Ben Price" userId="64e0ee70-be78-4126-b6bb-b74f31a45510" providerId="ADAL" clId="{18A030CA-30BC-4F94-8432-9115970381F7}" dt="2025-06-16T16:15:11.508" v="469" actId="14826"/>
        <pc:sldMkLst>
          <pc:docMk/>
          <pc:sldMk cId="2160345174" sldId="286"/>
        </pc:sldMkLst>
      </pc:sldChg>
      <pc:sldChg chg="modSp add del mod">
        <pc:chgData name="Ben Price" userId="64e0ee70-be78-4126-b6bb-b74f31a45510" providerId="ADAL" clId="{18A030CA-30BC-4F94-8432-9115970381F7}" dt="2025-06-16T16:13:58.269" v="436" actId="47"/>
        <pc:sldMkLst>
          <pc:docMk/>
          <pc:sldMk cId="4193759300" sldId="286"/>
        </pc:sldMkLst>
      </pc:sldChg>
      <pc:sldChg chg="modSp add del mod">
        <pc:chgData name="Ben Price" userId="64e0ee70-be78-4126-b6bb-b74f31a45510" providerId="ADAL" clId="{18A030CA-30BC-4F94-8432-9115970381F7}" dt="2025-06-16T16:16:57.257" v="488" actId="47"/>
        <pc:sldMkLst>
          <pc:docMk/>
          <pc:sldMk cId="596931985" sldId="287"/>
        </pc:sldMkLst>
      </pc:sldChg>
      <pc:sldChg chg="modSp add mod ord">
        <pc:chgData name="Ben Price" userId="64e0ee70-be78-4126-b6bb-b74f31a45510" providerId="ADAL" clId="{18A030CA-30BC-4F94-8432-9115970381F7}" dt="2025-06-16T16:15:44.880" v="480" actId="14826"/>
        <pc:sldMkLst>
          <pc:docMk/>
          <pc:sldMk cId="3237148080" sldId="288"/>
        </pc:sldMkLst>
      </pc:sldChg>
      <pc:sldChg chg="modSp add mod ord">
        <pc:chgData name="Ben Price" userId="64e0ee70-be78-4126-b6bb-b74f31a45510" providerId="ADAL" clId="{18A030CA-30BC-4F94-8432-9115970381F7}" dt="2025-06-16T16:17:48.718" v="516" actId="14826"/>
        <pc:sldMkLst>
          <pc:docMk/>
          <pc:sldMk cId="3550454679" sldId="289"/>
        </pc:sldMkLst>
      </pc:sldChg>
      <pc:sldChg chg="modSp add mod ord">
        <pc:chgData name="Ben Price" userId="64e0ee70-be78-4126-b6bb-b74f31a45510" providerId="ADAL" clId="{18A030CA-30BC-4F94-8432-9115970381F7}" dt="2025-06-16T16:18:15.871" v="517" actId="14826"/>
        <pc:sldMkLst>
          <pc:docMk/>
          <pc:sldMk cId="295452810" sldId="290"/>
        </pc:sldMkLst>
      </pc:sldChg>
      <pc:sldChg chg="modSp add mod ord">
        <pc:chgData name="Ben Price" userId="64e0ee70-be78-4126-b6bb-b74f31a45510" providerId="ADAL" clId="{18A030CA-30BC-4F94-8432-9115970381F7}" dt="2025-06-16T16:19:09.676" v="525" actId="14826"/>
        <pc:sldMkLst>
          <pc:docMk/>
          <pc:sldMk cId="3156378891" sldId="291"/>
        </pc:sldMkLst>
      </pc:sldChg>
      <pc:sldChg chg="modSp add mod">
        <pc:chgData name="Ben Price" userId="64e0ee70-be78-4126-b6bb-b74f31a45510" providerId="ADAL" clId="{18A030CA-30BC-4F94-8432-9115970381F7}" dt="2025-06-16T16:19:27.487" v="544" actId="14826"/>
        <pc:sldMkLst>
          <pc:docMk/>
          <pc:sldMk cId="522057336" sldId="292"/>
        </pc:sldMkLst>
      </pc:sldChg>
      <pc:sldChg chg="modSp add mod ord">
        <pc:chgData name="Ben Price" userId="64e0ee70-be78-4126-b6bb-b74f31a45510" providerId="ADAL" clId="{18A030CA-30BC-4F94-8432-9115970381F7}" dt="2025-06-16T16:20:18.184" v="557" actId="732"/>
        <pc:sldMkLst>
          <pc:docMk/>
          <pc:sldMk cId="2577212698" sldId="293"/>
        </pc:sldMkLst>
      </pc:sldChg>
      <pc:sldChg chg="modSp add mod ord">
        <pc:chgData name="Ben Price" userId="64e0ee70-be78-4126-b6bb-b74f31a45510" providerId="ADAL" clId="{18A030CA-30BC-4F94-8432-9115970381F7}" dt="2025-06-16T16:20:58.008" v="569" actId="14826"/>
        <pc:sldMkLst>
          <pc:docMk/>
          <pc:sldMk cId="4169145932" sldId="294"/>
        </pc:sldMkLst>
      </pc:sldChg>
      <pc:sldChg chg="modSp add mod ord">
        <pc:chgData name="Ben Price" userId="64e0ee70-be78-4126-b6bb-b74f31a45510" providerId="ADAL" clId="{18A030CA-30BC-4F94-8432-9115970381F7}" dt="2025-06-16T16:21:58.194" v="579" actId="14826"/>
        <pc:sldMkLst>
          <pc:docMk/>
          <pc:sldMk cId="1107607044" sldId="295"/>
        </pc:sldMkLst>
      </pc:sldChg>
      <pc:sldChg chg="modSp add mod ord">
        <pc:chgData name="Ben Price" userId="64e0ee70-be78-4126-b6bb-b74f31a45510" providerId="ADAL" clId="{18A030CA-30BC-4F94-8432-9115970381F7}" dt="2025-06-16T16:23:13.094" v="622" actId="14826"/>
        <pc:sldMkLst>
          <pc:docMk/>
          <pc:sldMk cId="2479035802" sldId="296"/>
        </pc:sldMkLst>
      </pc:sldChg>
      <pc:sldChg chg="modSp add del mod">
        <pc:chgData name="Ben Price" userId="64e0ee70-be78-4126-b6bb-b74f31a45510" providerId="ADAL" clId="{18A030CA-30BC-4F94-8432-9115970381F7}" dt="2025-06-16T16:22:40.640" v="599" actId="47"/>
        <pc:sldMkLst>
          <pc:docMk/>
          <pc:sldMk cId="3262725890" sldId="296"/>
        </pc:sldMkLst>
      </pc:sldChg>
      <pc:sldChg chg="modSp add mod ord">
        <pc:chgData name="Ben Price" userId="64e0ee70-be78-4126-b6bb-b74f31a45510" providerId="ADAL" clId="{18A030CA-30BC-4F94-8432-9115970381F7}" dt="2025-06-16T16:24:01.472" v="632" actId="14826"/>
        <pc:sldMkLst>
          <pc:docMk/>
          <pc:sldMk cId="3282927684" sldId="297"/>
        </pc:sldMkLst>
      </pc:sldChg>
      <pc:sldChg chg="modSp add mod ord">
        <pc:chgData name="Ben Price" userId="64e0ee70-be78-4126-b6bb-b74f31a45510" providerId="ADAL" clId="{18A030CA-30BC-4F94-8432-9115970381F7}" dt="2025-06-16T16:25:12.165" v="640" actId="14826"/>
        <pc:sldMkLst>
          <pc:docMk/>
          <pc:sldMk cId="4013433880" sldId="298"/>
        </pc:sldMkLst>
      </pc:sldChg>
      <pc:sldChg chg="modSp add mod">
        <pc:chgData name="Ben Price" userId="64e0ee70-be78-4126-b6bb-b74f31a45510" providerId="ADAL" clId="{18A030CA-30BC-4F94-8432-9115970381F7}" dt="2025-06-16T16:25:48.141" v="661" actId="14826"/>
        <pc:sldMkLst>
          <pc:docMk/>
          <pc:sldMk cId="1236230890" sldId="299"/>
        </pc:sldMkLst>
      </pc:sldChg>
      <pc:sldChg chg="modSp add mod ord">
        <pc:chgData name="Ben Price" userId="64e0ee70-be78-4126-b6bb-b74f31a45510" providerId="ADAL" clId="{18A030CA-30BC-4F94-8432-9115970381F7}" dt="2025-06-16T16:27:07.049" v="693" actId="20577"/>
        <pc:sldMkLst>
          <pc:docMk/>
          <pc:sldMk cId="1199786667" sldId="300"/>
        </pc:sldMkLst>
      </pc:sldChg>
      <pc:sldChg chg="modSp add mod ord">
        <pc:chgData name="Ben Price" userId="64e0ee70-be78-4126-b6bb-b74f31a45510" providerId="ADAL" clId="{18A030CA-30BC-4F94-8432-9115970381F7}" dt="2025-06-16T16:27:45.525" v="717" actId="1076"/>
        <pc:sldMkLst>
          <pc:docMk/>
          <pc:sldMk cId="4094943068" sldId="301"/>
        </pc:sldMkLst>
      </pc:sldChg>
      <pc:sldChg chg="modSp add mod ord">
        <pc:chgData name="Ben Price" userId="64e0ee70-be78-4126-b6bb-b74f31a45510" providerId="ADAL" clId="{18A030CA-30BC-4F94-8432-9115970381F7}" dt="2025-06-16T16:29:38.833" v="736" actId="14826"/>
        <pc:sldMkLst>
          <pc:docMk/>
          <pc:sldMk cId="1521589475" sldId="302"/>
        </pc:sldMkLst>
      </pc:sldChg>
      <pc:sldChg chg="modSp add mod">
        <pc:chgData name="Ben Price" userId="64e0ee70-be78-4126-b6bb-b74f31a45510" providerId="ADAL" clId="{18A030CA-30BC-4F94-8432-9115970381F7}" dt="2025-06-16T16:30:58.957" v="755" actId="20577"/>
        <pc:sldMkLst>
          <pc:docMk/>
          <pc:sldMk cId="2047555123" sldId="303"/>
        </pc:sldMkLst>
      </pc:sldChg>
      <pc:sldChg chg="modSp add mod ord">
        <pc:chgData name="Ben Price" userId="64e0ee70-be78-4126-b6bb-b74f31a45510" providerId="ADAL" clId="{18A030CA-30BC-4F94-8432-9115970381F7}" dt="2025-06-16T16:31:29.178" v="774" actId="14826"/>
        <pc:sldMkLst>
          <pc:docMk/>
          <pc:sldMk cId="2493529578" sldId="304"/>
        </pc:sldMkLst>
      </pc:sldChg>
      <pc:sldChg chg="modSp add mod ord">
        <pc:chgData name="Ben Price" userId="64e0ee70-be78-4126-b6bb-b74f31a45510" providerId="ADAL" clId="{18A030CA-30BC-4F94-8432-9115970381F7}" dt="2025-06-16T16:32:32.387" v="799" actId="14100"/>
        <pc:sldMkLst>
          <pc:docMk/>
          <pc:sldMk cId="878087411" sldId="305"/>
        </pc:sldMkLst>
      </pc:sldChg>
      <pc:sldChg chg="modSp add mod ord">
        <pc:chgData name="Ben Price" userId="64e0ee70-be78-4126-b6bb-b74f31a45510" providerId="ADAL" clId="{18A030CA-30BC-4F94-8432-9115970381F7}" dt="2025-06-16T16:33:14.261" v="815" actId="14826"/>
        <pc:sldMkLst>
          <pc:docMk/>
          <pc:sldMk cId="3697544981" sldId="306"/>
        </pc:sldMkLst>
      </pc:sldChg>
      <pc:sldChg chg="modSp add mod">
        <pc:chgData name="Ben Price" userId="64e0ee70-be78-4126-b6bb-b74f31a45510" providerId="ADAL" clId="{18A030CA-30BC-4F94-8432-9115970381F7}" dt="2025-06-16T16:33:33.451" v="834" actId="14826"/>
        <pc:sldMkLst>
          <pc:docMk/>
          <pc:sldMk cId="3842065677" sldId="307"/>
        </pc:sldMkLst>
      </pc:sldChg>
      <pc:sldChg chg="modSp add mod ord">
        <pc:chgData name="Ben Price" userId="64e0ee70-be78-4126-b6bb-b74f31a45510" providerId="ADAL" clId="{18A030CA-30BC-4F94-8432-9115970381F7}" dt="2025-06-16T16:34:11.526" v="867" actId="14826"/>
        <pc:sldMkLst>
          <pc:docMk/>
          <pc:sldMk cId="1801483572" sldId="30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A0C8AC-0B88-4F89-BB28-9B9B2F9F2E37}" type="datetimeFigureOut">
              <a:rPr lang="en-GB" smtClean="0"/>
              <a:t>29/09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235035-BC5D-4FFF-B413-CA5FD9BC2F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07559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AB2ED-17A7-7C99-6132-513BE9B722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E04BA9-7E1B-5033-9240-209472EDD5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7B0FD5-EB33-2360-BD5E-32324CFC6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2EEA0-9856-4CE8-BE1F-FCDFD345732B}" type="datetime1">
              <a:rPr lang="en-GB" smtClean="0"/>
              <a:t>29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96B810-5000-215B-966D-FC421D84F9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DC04DD-A6AC-08E6-3163-A9CCB3F37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0205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55B94F-E8D4-BB16-73E9-ED772D8BBE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E62625-47AB-78A0-B6F0-3CC2C58BC8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3EB23F-BE3F-938B-F74C-D6F6443F2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8C0D97-0FCE-4E81-8487-0663404C171A}" type="datetime1">
              <a:rPr lang="en-GB" smtClean="0"/>
              <a:t>29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18947E-4873-B6D5-2FE6-9192385B66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30D599-603C-928A-DB98-BBACC23B37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9411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6C0791-B980-715A-FA13-81E1A28804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1C4B67-F517-F971-45C5-1580FCA270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072E18-071B-B3AE-383F-CDC5E6A81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38840-7E87-426D-A774-0BDAB1106004}" type="datetime1">
              <a:rPr lang="en-GB" smtClean="0"/>
              <a:t>29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528A61-F17E-DAEB-497E-18983DE48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935748-A385-9BFD-CB73-A8EF42E854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10327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01AE94-241E-A758-044D-DAFCD9FBA2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DD8A4D-608A-9BA1-5BE6-A0EEA269DF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C00107-FDD1-3211-CFA8-04439ED93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65CA7-965A-442A-9ADB-110422D7B4B5}" type="datetime1">
              <a:rPr lang="en-GB" smtClean="0"/>
              <a:t>29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3E3F5-E38D-FE47-654E-B478BA55D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D6DC99-A5D4-017A-0706-22C6D3572A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2374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C97CE8-F3EF-DD2A-E10B-DFCEFA67EC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92A1BC-A522-E4A0-83AD-961722427B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2193A5-B1AD-D954-E378-693D5E588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80E42-F801-4C79-BF8C-062C20423550}" type="datetime1">
              <a:rPr lang="en-GB" smtClean="0"/>
              <a:t>29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1E952-079D-E6E9-1687-AFB824AACB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CC510F-0C87-1A77-FACF-5AD3E9CD3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6446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9A70EC-8DF3-939B-0D4B-63EB592520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D95F0A-A509-A290-4C27-6EB814F392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1E8F8E-8C24-F04A-D9F6-93AC101BD6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C0BA25-C0E6-0498-C3A2-ADEF47A6E3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8C9CD-81EB-44F5-9CF0-EFD5119BA0CE}" type="datetime1">
              <a:rPr lang="en-GB" smtClean="0"/>
              <a:t>29/09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8AE521-B015-11F8-1462-983A4EA7D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7370A6-45A8-5720-59EA-36409953D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079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008454-B19E-2006-8ED9-F4B99B7B59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D9BD5A-91E6-8640-6803-62FB4EF4ED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585688-A59A-FA06-F5FE-CE050A602C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1B1B455-8CF7-1AC3-7650-61689EEC5D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8DEC276-F7BD-B59D-C24E-4456B658D8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38102E-CD05-C0E7-292B-2CC6F5988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E3DD4-227F-4578-ABB6-87B761D7CC71}" type="datetime1">
              <a:rPr lang="en-GB" smtClean="0"/>
              <a:t>29/09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ED9F54F-DA94-686C-B7D1-18341EEA6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4E5A8F-C119-2AEA-C956-A877B76C4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8321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0D16F8-0CE7-839C-A0AF-9C4FD23600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B6A7CA9-01CE-4D45-A435-15F404556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9589BB-BE14-433D-98B2-D6C114A6A6DE}" type="datetime1">
              <a:rPr lang="en-GB" smtClean="0"/>
              <a:t>29/09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ACE41-AA94-499A-461E-0B7D46F44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764C32-A37B-8478-A674-AEE34DBAC2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4998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CEC1A4-B0DE-9E18-9B5D-B013C1857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1D508-EB86-4898-B0ED-DCF71B57252D}" type="datetime1">
              <a:rPr lang="en-GB" smtClean="0"/>
              <a:t>29/09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31FC1B-F340-86B4-7B64-8147B9099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596DA6-2A85-EF47-6CBC-7379A75F9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7844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2D9D45-954B-3DF8-13C7-2300B0FEF1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26D89F-830D-FF36-2162-D628796EA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E6C10C-8796-BFC9-CAFF-0266198668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2ED027-2C56-D439-382C-3A7942389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0E38A-35FF-4301-ADB1-FCF1D4E51AD7}" type="datetime1">
              <a:rPr lang="en-GB" smtClean="0"/>
              <a:t>29/09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567ED6-C31E-DB5D-843E-58C29A5C6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C195F1-03D7-9EE5-9FC9-345C146D2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8332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475969-DEC7-0CE9-5418-547235CAC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9ABA28-0D40-3EB9-B9EE-162816F071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56F46B-2F96-244D-4EC4-3BE4529969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094E9B-03E2-EE66-A840-98E27549E1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AC5B47-05D9-43BD-BB9A-994F177A4B48}" type="datetime1">
              <a:rPr lang="en-GB" smtClean="0"/>
              <a:t>29/09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020E0F-AB4E-FBA6-083C-A33CEBA1F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8BADE2-6F9E-1469-45CD-9E827ABED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8902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FCAE291-0083-C45C-9F5B-7E60AA7DFB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4FE6DC-FC9F-0EC2-3727-E90ED18381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4743AE-8D26-6A70-028F-9BA5A30008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724A3E2-0629-430D-8059-3C950C547626}" type="datetime1">
              <a:rPr lang="en-GB" smtClean="0"/>
              <a:t>29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8406FC-3854-B201-2247-5BF314D6E4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0F686F-C370-727F-8C28-D6D9BF1962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FBEF786-D0A4-4F25-B00E-C4472C9218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53604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1E245-9856-D9B0-AA67-0BDD89CB6F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22400" y="1034472"/>
            <a:ext cx="9144000" cy="886836"/>
          </a:xfrm>
        </p:spPr>
        <p:txBody>
          <a:bodyPr>
            <a:normAutofit fontScale="90000"/>
          </a:bodyPr>
          <a:lstStyle/>
          <a:p>
            <a:r>
              <a:rPr lang="en-GB" dirty="0"/>
              <a:t>Supplementary II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8B8AFC-25D0-BB8D-93E2-C386454844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422400" y="2382838"/>
            <a:ext cx="9144000" cy="618980"/>
          </a:xfrm>
        </p:spPr>
        <p:txBody>
          <a:bodyPr/>
          <a:lstStyle/>
          <a:p>
            <a:r>
              <a:rPr lang="en-GB" dirty="0"/>
              <a:t>Meta-analysis Forest Plot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6EB2E8-182D-FE0C-8924-2279851BC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7458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75" t="26072" r="15983" b="24011"/>
          <a:stretch/>
        </p:blipFill>
        <p:spPr>
          <a:xfrm>
            <a:off x="491705" y="254955"/>
            <a:ext cx="7513607" cy="5561353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362D523-CDD9-158C-6F0B-EB11429A3B40}"/>
              </a:ext>
            </a:extLst>
          </p:cNvPr>
          <p:cNvSpPr txBox="1"/>
          <p:nvPr/>
        </p:nvSpPr>
        <p:spPr>
          <a:xfrm>
            <a:off x="8556510" y="859185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Healthy</a:t>
            </a:r>
          </a:p>
          <a:p>
            <a:r>
              <a:rPr lang="en-GB" dirty="0"/>
              <a:t>1 = </a:t>
            </a:r>
            <a:r>
              <a:rPr lang="en-GB" b="0" i="0" dirty="0">
                <a:solidFill>
                  <a:srgbClr val="001D35"/>
                </a:solidFill>
                <a:effectLst/>
                <a:latin typeface="Google Sans"/>
              </a:rPr>
              <a:t>≥1 CVD Risk Factor</a:t>
            </a:r>
          </a:p>
          <a:p>
            <a:r>
              <a:rPr lang="en-GB" b="0" i="0" dirty="0">
                <a:solidFill>
                  <a:srgbClr val="001D35"/>
                </a:solidFill>
                <a:effectLst/>
                <a:latin typeface="Google Sans"/>
              </a:rPr>
              <a:t>2 = CHF</a:t>
            </a:r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ADD624-E0BF-7BAB-D9B5-CC045598B484}"/>
              </a:ext>
            </a:extLst>
          </p:cNvPr>
          <p:cNvSpPr txBox="1"/>
          <p:nvPr/>
        </p:nvSpPr>
        <p:spPr>
          <a:xfrm>
            <a:off x="783182" y="5864381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I</a:t>
            </a:r>
            <a:r>
              <a:rPr lang="en-GB" sz="1400" dirty="0"/>
              <a:t>. Pooled effect estimate of the flow-mediated dilation response to multiple-bouts of heat thermotherapy (HT) for different health statuses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7572B2C4-6FB7-101D-0CA3-535FD99DA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10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5073C2D-7683-703C-37BE-55B21C28DD69}"/>
              </a:ext>
            </a:extLst>
          </p:cNvPr>
          <p:cNvSpPr txBox="1"/>
          <p:nvPr/>
        </p:nvSpPr>
        <p:spPr>
          <a:xfrm>
            <a:off x="4425536" y="5501791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36781215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721" b="29890"/>
          <a:stretch/>
        </p:blipFill>
        <p:spPr>
          <a:xfrm>
            <a:off x="174473" y="810883"/>
            <a:ext cx="11482492" cy="4408097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2CD0A97-722E-893A-7224-33D775CB59F7}"/>
              </a:ext>
            </a:extLst>
          </p:cNvPr>
          <p:cNvSpPr txBox="1"/>
          <p:nvPr/>
        </p:nvSpPr>
        <p:spPr>
          <a:xfrm>
            <a:off x="843567" y="5398554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J</a:t>
            </a:r>
            <a:r>
              <a:rPr lang="en-GB" sz="1400" dirty="0"/>
              <a:t>. Pooled effect estimate of glucose (fasting, postprandial or mixed-meal) response to a single bout of heat thermotherapy (HT)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0329DF-035C-6973-C560-2A1CED0AA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11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0890503-77AA-B7CC-748F-86B5AFE602C9}"/>
              </a:ext>
            </a:extLst>
          </p:cNvPr>
          <p:cNvSpPr txBox="1"/>
          <p:nvPr/>
        </p:nvSpPr>
        <p:spPr>
          <a:xfrm>
            <a:off x="9163791" y="5010145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255939061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73" t="21187" r="14862" b="20139"/>
          <a:stretch/>
        </p:blipFill>
        <p:spPr>
          <a:xfrm>
            <a:off x="670731" y="184061"/>
            <a:ext cx="6340415" cy="5506149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26699F5-1F96-5486-40A1-438AC6CE63B8}"/>
              </a:ext>
            </a:extLst>
          </p:cNvPr>
          <p:cNvSpPr txBox="1"/>
          <p:nvPr/>
        </p:nvSpPr>
        <p:spPr>
          <a:xfrm>
            <a:off x="7505243" y="936616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HWI</a:t>
            </a:r>
          </a:p>
          <a:p>
            <a:r>
              <a:rPr lang="en-GB" dirty="0"/>
              <a:t>1 = Sauna</a:t>
            </a:r>
          </a:p>
          <a:p>
            <a:r>
              <a:rPr lang="en-GB" dirty="0"/>
              <a:t>2 = Water-perfused sui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509314B-EDE3-BFF6-6C94-21694A0FA9B7}"/>
              </a:ext>
            </a:extLst>
          </p:cNvPr>
          <p:cNvSpPr txBox="1"/>
          <p:nvPr/>
        </p:nvSpPr>
        <p:spPr>
          <a:xfrm>
            <a:off x="783182" y="5864381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K</a:t>
            </a:r>
            <a:r>
              <a:rPr lang="en-GB" sz="1400" dirty="0"/>
              <a:t>. Pooled effect estimate of glucose (fasting, postprandial or mixed-meal) response to a single bout of heat thermotherapy (HT) for different heating modalities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2FC70402-0F89-75A8-EE3B-38884A03E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12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838DBB6-8BCD-22E7-AAC4-DB4BE313BF37}"/>
              </a:ext>
            </a:extLst>
          </p:cNvPr>
          <p:cNvSpPr txBox="1"/>
          <p:nvPr/>
        </p:nvSpPr>
        <p:spPr>
          <a:xfrm>
            <a:off x="3752601" y="5438742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262951497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3" t="35294" r="5839" b="31389"/>
          <a:stretch/>
        </p:blipFill>
        <p:spPr>
          <a:xfrm>
            <a:off x="754894" y="1414416"/>
            <a:ext cx="10079881" cy="3802984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659F9D8-4A6B-E0B9-6607-FD19AF1C684B}"/>
              </a:ext>
            </a:extLst>
          </p:cNvPr>
          <p:cNvSpPr txBox="1"/>
          <p:nvPr/>
        </p:nvSpPr>
        <p:spPr>
          <a:xfrm>
            <a:off x="817687" y="5217400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L</a:t>
            </a:r>
            <a:r>
              <a:rPr lang="en-GB" sz="1400" dirty="0"/>
              <a:t>. Pooled effect estimate of glucose (fasting, postprandial or mixed-meal) response to multiple-bouts of heat thermotherapy (HT) after publication outliers were removed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6C1D00-60B1-A9B8-F3B4-75071B4C2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13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A066CBF-F102-B080-622A-CE601CF9E63E}"/>
              </a:ext>
            </a:extLst>
          </p:cNvPr>
          <p:cNvSpPr txBox="1"/>
          <p:nvPr/>
        </p:nvSpPr>
        <p:spPr>
          <a:xfrm>
            <a:off x="8894617" y="4847980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20867212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412" b="29544"/>
          <a:stretch/>
        </p:blipFill>
        <p:spPr>
          <a:xfrm>
            <a:off x="260739" y="806570"/>
            <a:ext cx="11530193" cy="4386532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3D13C0F-4199-B134-3023-04761D605E99}"/>
              </a:ext>
            </a:extLst>
          </p:cNvPr>
          <p:cNvSpPr txBox="1"/>
          <p:nvPr/>
        </p:nvSpPr>
        <p:spPr>
          <a:xfrm>
            <a:off x="843567" y="5252476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M</a:t>
            </a:r>
            <a:r>
              <a:rPr lang="en-GB" sz="1400" dirty="0"/>
              <a:t>. Pooled effect estimate of the heat-shock protein response to a single bout of heat thermotherapy (HT)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3345B7-A081-80DC-08FA-8E4E6C3016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14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9877477-7860-8528-07D7-E8F83B61E72C}"/>
              </a:ext>
            </a:extLst>
          </p:cNvPr>
          <p:cNvSpPr txBox="1"/>
          <p:nvPr/>
        </p:nvSpPr>
        <p:spPr>
          <a:xfrm>
            <a:off x="9392392" y="4897563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161258465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62" t="26350" r="17701" b="25693"/>
          <a:stretch/>
        </p:blipFill>
        <p:spPr>
          <a:xfrm>
            <a:off x="783182" y="398140"/>
            <a:ext cx="6745856" cy="5083833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5DEA3B-801C-4EC6-DA86-88DDEFDA0AC3}"/>
              </a:ext>
            </a:extLst>
          </p:cNvPr>
          <p:cNvSpPr txBox="1"/>
          <p:nvPr/>
        </p:nvSpPr>
        <p:spPr>
          <a:xfrm>
            <a:off x="8263059" y="1295248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rest/passive thermoneutral control group 1 = exercising control group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DD3023F-584C-DDD4-5101-7BEDFC899ABE}"/>
              </a:ext>
            </a:extLst>
          </p:cNvPr>
          <p:cNvSpPr txBox="1"/>
          <p:nvPr/>
        </p:nvSpPr>
        <p:spPr>
          <a:xfrm>
            <a:off x="783182" y="5864381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N</a:t>
            </a:r>
            <a:r>
              <a:rPr lang="en-GB" sz="1400" dirty="0"/>
              <a:t>. Pooled effect estimate of the heat-shock protein response to a single bout of heat thermotherapy (HT) for different control group modalities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DC2640E1-19D9-8A2D-0E6D-FAD51D44D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15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CDE6DAE-5F3E-E7C6-2591-8D0E6B27F2E0}"/>
              </a:ext>
            </a:extLst>
          </p:cNvPr>
          <p:cNvSpPr txBox="1"/>
          <p:nvPr/>
        </p:nvSpPr>
        <p:spPr>
          <a:xfrm>
            <a:off x="4203863" y="5202634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30582462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86" t="37485" r="5032" b="35885"/>
          <a:stretch/>
        </p:blipFill>
        <p:spPr>
          <a:xfrm>
            <a:off x="524388" y="1517940"/>
            <a:ext cx="10017089" cy="2951463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A84897B-CBD7-ED7B-3DA7-1DF31C1A1881}"/>
              </a:ext>
            </a:extLst>
          </p:cNvPr>
          <p:cNvSpPr txBox="1"/>
          <p:nvPr/>
        </p:nvSpPr>
        <p:spPr>
          <a:xfrm>
            <a:off x="662412" y="4699814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O</a:t>
            </a:r>
            <a:r>
              <a:rPr lang="en-GB" sz="1400" dirty="0"/>
              <a:t>. Pooled effect estimate of the heat-shock protein response to multiple-bouts of heat thermotherapy (HT)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8439C9-CF6F-7F70-4C3C-3FFF684D3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16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02EA6D8-CEEF-06AF-96BD-344F5D7B633C}"/>
              </a:ext>
            </a:extLst>
          </p:cNvPr>
          <p:cNvSpPr txBox="1"/>
          <p:nvPr/>
        </p:nvSpPr>
        <p:spPr>
          <a:xfrm>
            <a:off x="8700653" y="4261887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393176251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23" t="33566" r="5261" b="30697"/>
          <a:stretch/>
        </p:blipFill>
        <p:spPr>
          <a:xfrm>
            <a:off x="737173" y="928800"/>
            <a:ext cx="10174411" cy="4080294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D081EB1-7DD2-0ABD-3D42-138FE71B6735}"/>
              </a:ext>
            </a:extLst>
          </p:cNvPr>
          <p:cNvSpPr txBox="1"/>
          <p:nvPr/>
        </p:nvSpPr>
        <p:spPr>
          <a:xfrm>
            <a:off x="815835" y="5211958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P</a:t>
            </a:r>
            <a:r>
              <a:rPr lang="en-GB" sz="1400" dirty="0"/>
              <a:t>. Pooled effect estimate of the interleukin-6 response to a single bout of heat thermotherapy (HT)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C629E565-56C3-4C05-6B7B-4F09CB9A2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17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0DBC17D-AF21-A6FE-87DD-A89EAD6728D2}"/>
              </a:ext>
            </a:extLst>
          </p:cNvPr>
          <p:cNvSpPr txBox="1"/>
          <p:nvPr/>
        </p:nvSpPr>
        <p:spPr>
          <a:xfrm>
            <a:off x="8957952" y="4636953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216034517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36" t="26994" r="18283" b="26893"/>
          <a:stretch/>
        </p:blipFill>
        <p:spPr>
          <a:xfrm>
            <a:off x="607096" y="254955"/>
            <a:ext cx="7209137" cy="5158595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5DEA3B-801C-4EC6-DA86-88DDEFDA0AC3}"/>
              </a:ext>
            </a:extLst>
          </p:cNvPr>
          <p:cNvSpPr txBox="1"/>
          <p:nvPr/>
        </p:nvSpPr>
        <p:spPr>
          <a:xfrm>
            <a:off x="8081905" y="1139973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rest/passive thermoneutral control group 1 = exercising control group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0A7626A-C175-13C1-21B9-B6F0E2321A20}"/>
              </a:ext>
            </a:extLst>
          </p:cNvPr>
          <p:cNvSpPr txBox="1"/>
          <p:nvPr/>
        </p:nvSpPr>
        <p:spPr>
          <a:xfrm>
            <a:off x="783182" y="5864381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Q</a:t>
            </a:r>
            <a:r>
              <a:rPr lang="en-GB" sz="1400" dirty="0"/>
              <a:t>. Pooled effect estimate of the interleukin-6 response to a single bout of heat thermotherapy (HT) for different control group modalities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C6256279-D2DF-6D21-03B2-A533B885D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18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ECDECD4-5B0E-7FCF-BDE8-AC64677B12FA}"/>
              </a:ext>
            </a:extLst>
          </p:cNvPr>
          <p:cNvSpPr txBox="1"/>
          <p:nvPr/>
        </p:nvSpPr>
        <p:spPr>
          <a:xfrm>
            <a:off x="4429495" y="5244273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323714808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81" t="22916" r="17149" b="22623"/>
          <a:stretch/>
        </p:blipFill>
        <p:spPr>
          <a:xfrm>
            <a:off x="694344" y="106428"/>
            <a:ext cx="6601029" cy="5550259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26699F5-1F96-5486-40A1-438AC6CE63B8}"/>
              </a:ext>
            </a:extLst>
          </p:cNvPr>
          <p:cNvSpPr txBox="1"/>
          <p:nvPr/>
        </p:nvSpPr>
        <p:spPr>
          <a:xfrm>
            <a:off x="7835050" y="764088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HWI</a:t>
            </a:r>
          </a:p>
          <a:p>
            <a:r>
              <a:rPr lang="en-GB" dirty="0"/>
              <a:t>1 = Sauna</a:t>
            </a:r>
          </a:p>
          <a:p>
            <a:r>
              <a:rPr lang="en-GB" dirty="0"/>
              <a:t>2 = Water perfused suit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45C770B-A566-6D38-CA2F-9C94F8BEF4A2}"/>
              </a:ext>
            </a:extLst>
          </p:cNvPr>
          <p:cNvSpPr txBox="1"/>
          <p:nvPr/>
        </p:nvSpPr>
        <p:spPr>
          <a:xfrm>
            <a:off x="783182" y="5864381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R</a:t>
            </a:r>
            <a:r>
              <a:rPr lang="en-GB" sz="1400" dirty="0"/>
              <a:t>. Pooled effect estimate of the interleukin-6 response to a single bout of heat thermotherapy (HT) for different heating group modalities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F690FC27-D008-5511-A0D3-CD985A645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19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46BFF52-4943-5D0B-246B-0CCB0C06EC68}"/>
              </a:ext>
            </a:extLst>
          </p:cNvPr>
          <p:cNvSpPr txBox="1"/>
          <p:nvPr/>
        </p:nvSpPr>
        <p:spPr>
          <a:xfrm>
            <a:off x="4061360" y="5421980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35504546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8EA387E1-A68E-3ABB-CD03-61721CD474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347" b="30347"/>
          <a:stretch/>
        </p:blipFill>
        <p:spPr>
          <a:xfrm>
            <a:off x="326700" y="385284"/>
            <a:ext cx="11749067" cy="461803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62FC4DD-87F6-2642-7F89-C457E4937E85}"/>
              </a:ext>
            </a:extLst>
          </p:cNvPr>
          <p:cNvSpPr txBox="1"/>
          <p:nvPr/>
        </p:nvSpPr>
        <p:spPr>
          <a:xfrm>
            <a:off x="955711" y="5226026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A</a:t>
            </a:r>
            <a:r>
              <a:rPr lang="en-GB" sz="1400" dirty="0"/>
              <a:t>. Pooled effect estimate of central and peripheral arterial stiffness to either single or multiple-bouts of heat thermotherapy (HT). </a:t>
            </a:r>
            <a:r>
              <a:rPr lang="en-GB" sz="1400" dirty="0">
                <a:effectLst/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>
              <a:latin typeface="Aptos" panose="020B0004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FA903C8E-440A-A6BB-C2C9-524B9512E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2</a:t>
            </a:fld>
            <a:endParaRPr lang="en-GB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291717C-56E9-BFCC-A7B2-BF1A41849323}"/>
              </a:ext>
            </a:extLst>
          </p:cNvPr>
          <p:cNvSpPr txBox="1"/>
          <p:nvPr/>
        </p:nvSpPr>
        <p:spPr>
          <a:xfrm>
            <a:off x="9626929" y="4776119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286495751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06" t="40081" r="6645" b="38536"/>
          <a:stretch/>
        </p:blipFill>
        <p:spPr>
          <a:xfrm>
            <a:off x="783182" y="1717941"/>
            <a:ext cx="10258214" cy="2540300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4825DEB-847D-78B6-4C7E-4C12BDB2FB23}"/>
              </a:ext>
            </a:extLst>
          </p:cNvPr>
          <p:cNvSpPr txBox="1"/>
          <p:nvPr/>
        </p:nvSpPr>
        <p:spPr>
          <a:xfrm>
            <a:off x="783182" y="4432396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S</a:t>
            </a:r>
            <a:r>
              <a:rPr lang="en-GB" sz="1400" dirty="0"/>
              <a:t>. Pooled effect estimate of the interleukin-6 response to multiple-bouts of heat thermotherapy (HT)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C416E6-A046-A0C9-22AA-7B977C819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20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B8B33BE-35EF-CE04-BE0B-FB31B4C07AC8}"/>
              </a:ext>
            </a:extLst>
          </p:cNvPr>
          <p:cNvSpPr txBox="1"/>
          <p:nvPr/>
        </p:nvSpPr>
        <p:spPr>
          <a:xfrm>
            <a:off x="9104414" y="3973567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29545281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46" t="14450" b="14450"/>
          <a:stretch/>
        </p:blipFill>
        <p:spPr>
          <a:xfrm>
            <a:off x="809052" y="211816"/>
            <a:ext cx="6229690" cy="5320145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5DEA3B-801C-4EC6-DA86-88DDEFDA0AC3}"/>
              </a:ext>
            </a:extLst>
          </p:cNvPr>
          <p:cNvSpPr txBox="1"/>
          <p:nvPr/>
        </p:nvSpPr>
        <p:spPr>
          <a:xfrm>
            <a:off x="6304864" y="717278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rest/passive thermoneutral control group 1 = exercising control group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8C9AA8F-9A04-6FE3-D6EE-738AFDB81FB8}"/>
              </a:ext>
            </a:extLst>
          </p:cNvPr>
          <p:cNvSpPr txBox="1"/>
          <p:nvPr/>
        </p:nvSpPr>
        <p:spPr>
          <a:xfrm>
            <a:off x="949411" y="5872181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T</a:t>
            </a:r>
            <a:r>
              <a:rPr lang="en-GB" sz="1400" dirty="0"/>
              <a:t>. Pooled subgroup effect estimate of mean arterial pressure to a single-bout of heat thermotherapy (HT) for different control group modalities. </a:t>
            </a:r>
            <a:r>
              <a:rPr lang="en-GB" sz="1400" dirty="0">
                <a:ea typeface="Aptos" panose="020B0004020202020204" pitchFamily="34" charset="0"/>
              </a:rPr>
              <a:t>Mean differences in the delta change (pre-post) between the intervention and control arms are presented in mm Hg. </a:t>
            </a:r>
            <a:endParaRPr lang="en-GB" sz="1400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5805D31-0CDB-130A-F28B-0A40D4415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21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769A14B-DAEC-C88D-B01D-E12A5055F7B8}"/>
              </a:ext>
            </a:extLst>
          </p:cNvPr>
          <p:cNvSpPr txBox="1"/>
          <p:nvPr/>
        </p:nvSpPr>
        <p:spPr>
          <a:xfrm>
            <a:off x="3206337" y="5422997"/>
            <a:ext cx="8114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Hg</a:t>
            </a:r>
          </a:p>
        </p:txBody>
      </p:sp>
    </p:spTree>
    <p:extLst>
      <p:ext uri="{BB962C8B-B14F-4D97-AF65-F5344CB8AC3E}">
        <p14:creationId xmlns:p14="http://schemas.microsoft.com/office/powerpoint/2010/main" val="257721269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12" t="9934" r="127" b="8818"/>
          <a:stretch/>
        </p:blipFill>
        <p:spPr>
          <a:xfrm>
            <a:off x="820016" y="187200"/>
            <a:ext cx="5655435" cy="5518726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ADF1E04-137B-9BBD-0C62-B3C3EB5D6434}"/>
              </a:ext>
            </a:extLst>
          </p:cNvPr>
          <p:cNvSpPr txBox="1"/>
          <p:nvPr/>
        </p:nvSpPr>
        <p:spPr>
          <a:xfrm>
            <a:off x="790589" y="6019175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U</a:t>
            </a:r>
            <a:r>
              <a:rPr lang="en-GB" sz="1400" dirty="0"/>
              <a:t>. Pooled subgroup effect estimate of mean arterial pressure to a single-bout of heat thermotherapy (HT) for different heating group modalities. </a:t>
            </a:r>
            <a:r>
              <a:rPr lang="en-GB" sz="1400" dirty="0">
                <a:ea typeface="Aptos" panose="020B0004020202020204" pitchFamily="34" charset="0"/>
              </a:rPr>
              <a:t>Mean differences in the delta change (pre-post) between the intervention and control arms are presented in mm Hg. </a:t>
            </a:r>
            <a:endParaRPr lang="en-GB" sz="14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7FA89E1-C8A0-E8F3-C08E-A910031F81D0}"/>
              </a:ext>
            </a:extLst>
          </p:cNvPr>
          <p:cNvSpPr txBox="1"/>
          <p:nvPr/>
        </p:nvSpPr>
        <p:spPr>
          <a:xfrm>
            <a:off x="6202061" y="500449"/>
            <a:ext cx="253390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HWI</a:t>
            </a:r>
          </a:p>
          <a:p>
            <a:r>
              <a:rPr lang="en-GB" dirty="0"/>
              <a:t>1 = Sauna</a:t>
            </a:r>
          </a:p>
          <a:p>
            <a:r>
              <a:rPr lang="en-GB" dirty="0"/>
              <a:t>2 = Water perfused suit</a:t>
            </a:r>
          </a:p>
          <a:p>
            <a:r>
              <a:rPr lang="en-GB" dirty="0"/>
              <a:t>3 = Heating Pad</a:t>
            </a: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E109C1-1E79-45D3-241C-9770C9287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22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24DB51D-A9C3-CBB9-33CF-05D31BCF8641}"/>
              </a:ext>
            </a:extLst>
          </p:cNvPr>
          <p:cNvSpPr txBox="1"/>
          <p:nvPr/>
        </p:nvSpPr>
        <p:spPr>
          <a:xfrm>
            <a:off x="2980706" y="5581654"/>
            <a:ext cx="8114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Hg</a:t>
            </a:r>
          </a:p>
        </p:txBody>
      </p:sp>
    </p:spTree>
    <p:extLst>
      <p:ext uri="{BB962C8B-B14F-4D97-AF65-F5344CB8AC3E}">
        <p14:creationId xmlns:p14="http://schemas.microsoft.com/office/powerpoint/2010/main" val="416914593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33" t="30244" r="17710" b="29950"/>
          <a:stretch/>
        </p:blipFill>
        <p:spPr>
          <a:xfrm>
            <a:off x="943482" y="854015"/>
            <a:ext cx="7480870" cy="4677946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5DEA3B-801C-4EC6-DA86-88DDEFDA0AC3}"/>
              </a:ext>
            </a:extLst>
          </p:cNvPr>
          <p:cNvSpPr txBox="1"/>
          <p:nvPr/>
        </p:nvSpPr>
        <p:spPr>
          <a:xfrm>
            <a:off x="8562111" y="1476403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rest/passive thermoneutral control group 1 = exercising control group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C573873-0361-B3AD-4089-D394C9DB24C6}"/>
              </a:ext>
            </a:extLst>
          </p:cNvPr>
          <p:cNvSpPr txBox="1"/>
          <p:nvPr/>
        </p:nvSpPr>
        <p:spPr>
          <a:xfrm>
            <a:off x="961287" y="5757386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V</a:t>
            </a:r>
            <a:r>
              <a:rPr lang="en-GB" sz="1400" dirty="0"/>
              <a:t>. Pooled subgroup effect estimate of mean arterial pressure to multiple-bouts of heat thermotherapy (HT) for different control group modalities. </a:t>
            </a:r>
            <a:r>
              <a:rPr lang="en-GB" sz="1400" dirty="0">
                <a:ea typeface="Aptos" panose="020B0004020202020204" pitchFamily="34" charset="0"/>
              </a:rPr>
              <a:t>Mean differences in the delta change (pre-post) between the intervention and control arms are presented in mm Hg. 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5544119C-A61C-CC9C-D63D-5022EB83B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23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5F2CDFC-1E8D-A101-7270-4A932B31BD76}"/>
              </a:ext>
            </a:extLst>
          </p:cNvPr>
          <p:cNvSpPr txBox="1"/>
          <p:nvPr/>
        </p:nvSpPr>
        <p:spPr>
          <a:xfrm>
            <a:off x="4860967" y="5268937"/>
            <a:ext cx="8114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Hg</a:t>
            </a:r>
          </a:p>
        </p:txBody>
      </p:sp>
    </p:spTree>
    <p:extLst>
      <p:ext uri="{BB962C8B-B14F-4D97-AF65-F5344CB8AC3E}">
        <p14:creationId xmlns:p14="http://schemas.microsoft.com/office/powerpoint/2010/main" val="247903580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59" t="27684" r="16329" b="27585"/>
          <a:stretch/>
        </p:blipFill>
        <p:spPr>
          <a:xfrm>
            <a:off x="961287" y="457483"/>
            <a:ext cx="7063398" cy="4808066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362D523-CDD9-158C-6F0B-EB11429A3B40}"/>
              </a:ext>
            </a:extLst>
          </p:cNvPr>
          <p:cNvSpPr txBox="1"/>
          <p:nvPr/>
        </p:nvSpPr>
        <p:spPr>
          <a:xfrm>
            <a:off x="8182715" y="1126604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Healthy</a:t>
            </a:r>
          </a:p>
          <a:p>
            <a:r>
              <a:rPr lang="en-GB" dirty="0"/>
              <a:t>1 = </a:t>
            </a:r>
            <a:r>
              <a:rPr lang="en-GB" b="0" i="0" dirty="0">
                <a:solidFill>
                  <a:srgbClr val="001D35"/>
                </a:solidFill>
                <a:effectLst/>
                <a:latin typeface="Google Sans"/>
              </a:rPr>
              <a:t>≥1 CVD Risk Factor</a:t>
            </a:r>
          </a:p>
          <a:p>
            <a:r>
              <a:rPr lang="en-GB" b="0" i="0" dirty="0">
                <a:solidFill>
                  <a:srgbClr val="001D35"/>
                </a:solidFill>
                <a:effectLst/>
                <a:latin typeface="Google Sans"/>
              </a:rPr>
              <a:t>2= CHF</a:t>
            </a:r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9C9726B-78BC-5BBD-527E-A5F02F6FDE00}"/>
              </a:ext>
            </a:extLst>
          </p:cNvPr>
          <p:cNvSpPr txBox="1"/>
          <p:nvPr/>
        </p:nvSpPr>
        <p:spPr>
          <a:xfrm>
            <a:off x="961287" y="5757386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W</a:t>
            </a:r>
            <a:r>
              <a:rPr lang="en-GB" sz="1400" dirty="0"/>
              <a:t>. Pooled subgroup effect estimate of mean arterial pressure to multiple-bouts of heat thermotherapy (HT) for different participant health statuses. </a:t>
            </a:r>
            <a:r>
              <a:rPr lang="en-GB" sz="1400" dirty="0">
                <a:ea typeface="Aptos" panose="020B0004020202020204" pitchFamily="34" charset="0"/>
              </a:rPr>
              <a:t>Mean differences in the delta change (pre-post) between the intervention and control arms are presented in mm Hg. 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79FFAEFD-472D-6F13-B8EE-69DB5C399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24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B9DCE6F-7663-D097-E54A-00CBA4FFE64A}"/>
              </a:ext>
            </a:extLst>
          </p:cNvPr>
          <p:cNvSpPr txBox="1"/>
          <p:nvPr/>
        </p:nvSpPr>
        <p:spPr>
          <a:xfrm>
            <a:off x="4544291" y="5003636"/>
            <a:ext cx="8114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Hg</a:t>
            </a:r>
          </a:p>
        </p:txBody>
      </p:sp>
    </p:spTree>
    <p:extLst>
      <p:ext uri="{BB962C8B-B14F-4D97-AF65-F5344CB8AC3E}">
        <p14:creationId xmlns:p14="http://schemas.microsoft.com/office/powerpoint/2010/main" val="328292768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32" t="13156" b="13156"/>
          <a:stretch/>
        </p:blipFill>
        <p:spPr>
          <a:xfrm>
            <a:off x="570150" y="120410"/>
            <a:ext cx="6238223" cy="5513832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5DEA3B-801C-4EC6-DA86-88DDEFDA0AC3}"/>
              </a:ext>
            </a:extLst>
          </p:cNvPr>
          <p:cNvSpPr txBox="1"/>
          <p:nvPr/>
        </p:nvSpPr>
        <p:spPr>
          <a:xfrm>
            <a:off x="6096000" y="829422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rest/passive thermoneutral control group 1 = exercising control grou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1597F63-DAA5-20E0-2805-6F7CE8CFEE87}"/>
              </a:ext>
            </a:extLst>
          </p:cNvPr>
          <p:cNvSpPr txBox="1"/>
          <p:nvPr/>
        </p:nvSpPr>
        <p:spPr>
          <a:xfrm>
            <a:off x="633484" y="5998926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X</a:t>
            </a:r>
            <a:r>
              <a:rPr lang="en-GB" sz="1400" dirty="0"/>
              <a:t>. Pooled subgroup effect estimate of systolic blood pressure to a single-bout of heat thermotherapy (HT) for different control group modalities. </a:t>
            </a:r>
            <a:r>
              <a:rPr lang="en-GB" sz="1400" dirty="0">
                <a:ea typeface="Aptos" panose="020B0004020202020204" pitchFamily="34" charset="0"/>
              </a:rPr>
              <a:t>Mean differences in the delta change (pre-post) between the intervention and control arms are presented in mm Hg. </a:t>
            </a:r>
            <a:endParaRPr lang="en-GB" sz="1400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11EA83-8BC6-1A3C-7577-17135E7CB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25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E8AD943-F1DA-F789-94E4-33D738F3CA4D}"/>
              </a:ext>
            </a:extLst>
          </p:cNvPr>
          <p:cNvSpPr txBox="1"/>
          <p:nvPr/>
        </p:nvSpPr>
        <p:spPr>
          <a:xfrm>
            <a:off x="3071751" y="5577695"/>
            <a:ext cx="811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Hg</a:t>
            </a:r>
          </a:p>
        </p:txBody>
      </p:sp>
    </p:spTree>
    <p:extLst>
      <p:ext uri="{BB962C8B-B14F-4D97-AF65-F5344CB8AC3E}">
        <p14:creationId xmlns:p14="http://schemas.microsoft.com/office/powerpoint/2010/main" val="119978666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07" t="8163" r="13834" b="7447"/>
          <a:stretch/>
        </p:blipFill>
        <p:spPr>
          <a:xfrm>
            <a:off x="568472" y="157867"/>
            <a:ext cx="4980143" cy="5728336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9079FC7-22F3-0BE3-EA65-AED93C189621}"/>
              </a:ext>
            </a:extLst>
          </p:cNvPr>
          <p:cNvSpPr txBox="1"/>
          <p:nvPr/>
        </p:nvSpPr>
        <p:spPr>
          <a:xfrm>
            <a:off x="633484" y="6059310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Y</a:t>
            </a:r>
            <a:r>
              <a:rPr lang="en-GB" sz="1400" dirty="0"/>
              <a:t>. Pooled subgroup effect estimate of systolic blood pressure to a single-bout of heat thermotherapy (HT) for different heating modalities. </a:t>
            </a:r>
            <a:r>
              <a:rPr lang="en-GB" sz="1400" dirty="0">
                <a:ea typeface="Aptos" panose="020B0004020202020204" pitchFamily="34" charset="0"/>
              </a:rPr>
              <a:t>Mean differences in the delta change (pre-post) between the intervention and control arms are presented in mm Hg. 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19CE9EDB-4392-7D85-C0B1-7542C6320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26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56FB69C-D43A-2583-7337-AE0A85BD98DA}"/>
              </a:ext>
            </a:extLst>
          </p:cNvPr>
          <p:cNvSpPr txBox="1"/>
          <p:nvPr/>
        </p:nvSpPr>
        <p:spPr>
          <a:xfrm>
            <a:off x="5404145" y="309465"/>
            <a:ext cx="253390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HWI</a:t>
            </a:r>
          </a:p>
          <a:p>
            <a:r>
              <a:rPr lang="en-GB" dirty="0"/>
              <a:t>1 = Sauna</a:t>
            </a:r>
          </a:p>
          <a:p>
            <a:r>
              <a:rPr lang="en-GB" dirty="0"/>
              <a:t>2 = Water perfused suit</a:t>
            </a:r>
          </a:p>
          <a:p>
            <a:r>
              <a:rPr lang="en-GB" dirty="0"/>
              <a:t>3 = Heating Pa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4843DFE-E66A-E0F2-AC01-2D6977BC619E}"/>
              </a:ext>
            </a:extLst>
          </p:cNvPr>
          <p:cNvSpPr txBox="1"/>
          <p:nvPr/>
        </p:nvSpPr>
        <p:spPr>
          <a:xfrm>
            <a:off x="2956956" y="5747703"/>
            <a:ext cx="8114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Hg</a:t>
            </a:r>
          </a:p>
        </p:txBody>
      </p:sp>
    </p:spTree>
    <p:extLst>
      <p:ext uri="{BB962C8B-B14F-4D97-AF65-F5344CB8AC3E}">
        <p14:creationId xmlns:p14="http://schemas.microsoft.com/office/powerpoint/2010/main" val="409494306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30" t="27933" r="15581" b="26990"/>
          <a:stretch/>
        </p:blipFill>
        <p:spPr>
          <a:xfrm>
            <a:off x="633484" y="655608"/>
            <a:ext cx="7531555" cy="5037826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5DEA3B-801C-4EC6-DA86-88DDEFDA0AC3}"/>
              </a:ext>
            </a:extLst>
          </p:cNvPr>
          <p:cNvSpPr txBox="1"/>
          <p:nvPr/>
        </p:nvSpPr>
        <p:spPr>
          <a:xfrm>
            <a:off x="8305802" y="1053708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rest/passive thermoneutral control group 1 = exercising control group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66C57D9-8F8E-33C1-0FB3-E69925660EEC}"/>
              </a:ext>
            </a:extLst>
          </p:cNvPr>
          <p:cNvSpPr txBox="1"/>
          <p:nvPr/>
        </p:nvSpPr>
        <p:spPr>
          <a:xfrm>
            <a:off x="633484" y="5998926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Z</a:t>
            </a:r>
            <a:r>
              <a:rPr lang="en-GB" sz="1400" dirty="0"/>
              <a:t>. Pooled subgroup effect estimate of systolic blood pressure to multiple-bouts of heat thermotherapy (HT) for different control group modalities. </a:t>
            </a:r>
            <a:r>
              <a:rPr lang="en-GB" sz="1400" dirty="0">
                <a:ea typeface="Aptos" panose="020B0004020202020204" pitchFamily="34" charset="0"/>
              </a:rPr>
              <a:t>Mean differences in the delta change (pre-post) between the intervention and control arms are presented in mm Hg. 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C2020AC1-E2E7-01A5-E440-3361EFD3B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27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FAAE373-5A1D-4667-D760-5BB912B6AA64}"/>
              </a:ext>
            </a:extLst>
          </p:cNvPr>
          <p:cNvSpPr txBox="1"/>
          <p:nvPr/>
        </p:nvSpPr>
        <p:spPr>
          <a:xfrm>
            <a:off x="4399261" y="5439150"/>
            <a:ext cx="8114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Hg</a:t>
            </a:r>
          </a:p>
        </p:txBody>
      </p:sp>
    </p:spTree>
    <p:extLst>
      <p:ext uri="{BB962C8B-B14F-4D97-AF65-F5344CB8AC3E}">
        <p14:creationId xmlns:p14="http://schemas.microsoft.com/office/powerpoint/2010/main" val="2493529578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71" t="21813" r="15536" b="21813"/>
          <a:stretch/>
        </p:blipFill>
        <p:spPr>
          <a:xfrm>
            <a:off x="464091" y="0"/>
            <a:ext cx="7035399" cy="5859023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362D523-CDD9-158C-6F0B-EB11429A3B40}"/>
              </a:ext>
            </a:extLst>
          </p:cNvPr>
          <p:cNvSpPr txBox="1"/>
          <p:nvPr/>
        </p:nvSpPr>
        <p:spPr>
          <a:xfrm>
            <a:off x="7754253" y="1143856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Healthy</a:t>
            </a:r>
          </a:p>
          <a:p>
            <a:r>
              <a:rPr lang="en-GB" dirty="0"/>
              <a:t>1 = </a:t>
            </a:r>
            <a:r>
              <a:rPr lang="en-GB" b="0" i="0" dirty="0">
                <a:solidFill>
                  <a:srgbClr val="001D35"/>
                </a:solidFill>
                <a:effectLst/>
                <a:latin typeface="Google Sans"/>
              </a:rPr>
              <a:t>≥1 CVD Risk Factor</a:t>
            </a:r>
          </a:p>
          <a:p>
            <a:r>
              <a:rPr lang="en-GB" b="0" i="0" dirty="0">
                <a:solidFill>
                  <a:srgbClr val="001D35"/>
                </a:solidFill>
                <a:effectLst/>
                <a:latin typeface="Google Sans"/>
              </a:rPr>
              <a:t>2 = CHF</a:t>
            </a:r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D081B3E-6928-516C-F45F-4AC41EF30860}"/>
              </a:ext>
            </a:extLst>
          </p:cNvPr>
          <p:cNvSpPr txBox="1"/>
          <p:nvPr/>
        </p:nvSpPr>
        <p:spPr>
          <a:xfrm>
            <a:off x="633484" y="5998926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Aa</a:t>
            </a:r>
            <a:r>
              <a:rPr lang="en-GB" sz="1400" dirty="0"/>
              <a:t>. Pooled subgroup effect estimate of systolic blood pressure to multiple-bouts of heat thermotherapy (HT) for different participant health statuses. </a:t>
            </a:r>
            <a:r>
              <a:rPr lang="en-GB" sz="1400" dirty="0">
                <a:ea typeface="Aptos" panose="020B0004020202020204" pitchFamily="34" charset="0"/>
              </a:rPr>
              <a:t>Mean differences in the delta change (pre-post) between the intervention and control arms are presented in mm Hg. 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B878B9C6-EB48-C096-DB07-D819EECCE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28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6D9C795-479E-6520-6310-53114960C72E}"/>
              </a:ext>
            </a:extLst>
          </p:cNvPr>
          <p:cNvSpPr txBox="1"/>
          <p:nvPr/>
        </p:nvSpPr>
        <p:spPr>
          <a:xfrm>
            <a:off x="3950525" y="5458942"/>
            <a:ext cx="8114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Hg</a:t>
            </a:r>
          </a:p>
        </p:txBody>
      </p:sp>
    </p:spTree>
    <p:extLst>
      <p:ext uri="{BB962C8B-B14F-4D97-AF65-F5344CB8AC3E}">
        <p14:creationId xmlns:p14="http://schemas.microsoft.com/office/powerpoint/2010/main" val="878087411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78" t="21232" r="16504" b="19743"/>
          <a:stretch/>
        </p:blipFill>
        <p:spPr>
          <a:xfrm>
            <a:off x="508901" y="268202"/>
            <a:ext cx="6089896" cy="5403860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5DEA3B-801C-4EC6-DA86-88DDEFDA0AC3}"/>
              </a:ext>
            </a:extLst>
          </p:cNvPr>
          <p:cNvSpPr txBox="1"/>
          <p:nvPr/>
        </p:nvSpPr>
        <p:spPr>
          <a:xfrm>
            <a:off x="7158879" y="1096841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rest/passive thermoneutral control group 1 = exercising control group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8B35D42-3CB5-6947-C124-550199C9783E}"/>
              </a:ext>
            </a:extLst>
          </p:cNvPr>
          <p:cNvSpPr txBox="1"/>
          <p:nvPr/>
        </p:nvSpPr>
        <p:spPr>
          <a:xfrm>
            <a:off x="633484" y="5998926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Ab</a:t>
            </a:r>
            <a:r>
              <a:rPr lang="en-GB" sz="1400" dirty="0"/>
              <a:t>. Pooled subgroup effect estimate of the shear rate response to a single-bout of heat thermotherapy (HT) for different control group modalities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9D8CE4D4-3E13-6399-285F-DA14DB559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29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EB2E0DD-7BA1-0F9D-24BC-883CA88B62B5}"/>
              </a:ext>
            </a:extLst>
          </p:cNvPr>
          <p:cNvSpPr txBox="1"/>
          <p:nvPr/>
        </p:nvSpPr>
        <p:spPr>
          <a:xfrm>
            <a:off x="3594264" y="5496940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18014835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33" t="28522" r="9021" b="28522"/>
          <a:stretch/>
        </p:blipFill>
        <p:spPr>
          <a:xfrm>
            <a:off x="909529" y="589034"/>
            <a:ext cx="7746521" cy="4586815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A1A3B51-78B2-34A3-A256-42BA6ED97DAD}"/>
              </a:ext>
            </a:extLst>
          </p:cNvPr>
          <p:cNvSpPr txBox="1"/>
          <p:nvPr/>
        </p:nvSpPr>
        <p:spPr>
          <a:xfrm>
            <a:off x="8704053" y="1985993"/>
            <a:ext cx="342041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rest/passive thermoneutral control group</a:t>
            </a:r>
          </a:p>
          <a:p>
            <a:r>
              <a:rPr lang="en-GB" dirty="0"/>
              <a:t>1 = exercising control group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947D1A3-7A24-5EBD-5D38-A02F962CF8EF}"/>
              </a:ext>
            </a:extLst>
          </p:cNvPr>
          <p:cNvSpPr txBox="1"/>
          <p:nvPr/>
        </p:nvSpPr>
        <p:spPr>
          <a:xfrm>
            <a:off x="909529" y="5530302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B</a:t>
            </a:r>
            <a:r>
              <a:rPr lang="en-GB" sz="1400" dirty="0"/>
              <a:t>. Pooled subgroup effect estimate of arterial stiffness to either single or multiple-bouts of heat thermotherapy (HT) for different control group modalities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29C54D33-77DA-0135-2B07-2CAC1ECD4E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3</a:t>
            </a:fld>
            <a:endParaRPr lang="en-GB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0D80A7E-B4FA-38FA-42FB-0F55BB5E6253}"/>
              </a:ext>
            </a:extLst>
          </p:cNvPr>
          <p:cNvSpPr txBox="1"/>
          <p:nvPr/>
        </p:nvSpPr>
        <p:spPr>
          <a:xfrm>
            <a:off x="4397827" y="5133391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22565388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522" b="36299"/>
          <a:stretch/>
        </p:blipFill>
        <p:spPr>
          <a:xfrm>
            <a:off x="224286" y="1108754"/>
            <a:ext cx="11072387" cy="3895160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93F0C49-D4FB-FCD8-9323-BE80373DB0FF}"/>
              </a:ext>
            </a:extLst>
          </p:cNvPr>
          <p:cNvSpPr txBox="1"/>
          <p:nvPr/>
        </p:nvSpPr>
        <p:spPr>
          <a:xfrm>
            <a:off x="955711" y="5226026"/>
            <a:ext cx="1001708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C</a:t>
            </a:r>
            <a:r>
              <a:rPr lang="en-GB" sz="1400" dirty="0"/>
              <a:t>. Pooled effect estimate of C-reactive protein to a single-bout of heat thermotherapy (HT)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AE2A1E8D-1A5A-5ED5-7D7B-129A94961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4</a:t>
            </a:fld>
            <a:endParaRPr lang="en-GB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29D2B8C-D2DB-B08E-C8BA-D87CBD95DC33}"/>
              </a:ext>
            </a:extLst>
          </p:cNvPr>
          <p:cNvSpPr txBox="1"/>
          <p:nvPr/>
        </p:nvSpPr>
        <p:spPr>
          <a:xfrm>
            <a:off x="8802585" y="4776416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30962980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55" t="11611" b="11611"/>
          <a:stretch/>
        </p:blipFill>
        <p:spPr>
          <a:xfrm>
            <a:off x="690823" y="196526"/>
            <a:ext cx="6245525" cy="5215023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26699F5-1F96-5486-40A1-438AC6CE63B8}"/>
              </a:ext>
            </a:extLst>
          </p:cNvPr>
          <p:cNvSpPr txBox="1"/>
          <p:nvPr/>
        </p:nvSpPr>
        <p:spPr>
          <a:xfrm>
            <a:off x="7221137" y="1005530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rest/passive thermoneutral control group 1 = exercising control group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E53075-1172-A112-1BF0-DBDA9F40C4E7}"/>
              </a:ext>
            </a:extLst>
          </p:cNvPr>
          <p:cNvSpPr txBox="1"/>
          <p:nvPr/>
        </p:nvSpPr>
        <p:spPr>
          <a:xfrm>
            <a:off x="933280" y="5740100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D</a:t>
            </a:r>
            <a:r>
              <a:rPr lang="en-GB" sz="1400" dirty="0"/>
              <a:t>. Pooled subgroup effect estimate of diastolic blood pressure to a single-bout of heat thermotherapy (HT) for different control group modalities. </a:t>
            </a:r>
            <a:r>
              <a:rPr lang="en-GB" sz="1400" dirty="0">
                <a:effectLst/>
                <a:ea typeface="Aptos" panose="020B0004020202020204" pitchFamily="34" charset="0"/>
              </a:rPr>
              <a:t>Mean differences in the delta change (pre-post) between the intervention and control arms are presented in mm Hg. </a:t>
            </a:r>
            <a:endParaRPr lang="en-GB" sz="1400" dirty="0"/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CC664A86-2C94-0942-34EE-589AD55AE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5</a:t>
            </a:fld>
            <a:endParaRPr lang="en-GB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5D47DAF-2EAE-E3EE-93BC-F9DD92FD1553}"/>
              </a:ext>
            </a:extLst>
          </p:cNvPr>
          <p:cNvSpPr txBox="1"/>
          <p:nvPr/>
        </p:nvSpPr>
        <p:spPr>
          <a:xfrm>
            <a:off x="3218213" y="5253103"/>
            <a:ext cx="8114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Hg</a:t>
            </a:r>
          </a:p>
        </p:txBody>
      </p:sp>
    </p:spTree>
    <p:extLst>
      <p:ext uri="{BB962C8B-B14F-4D97-AF65-F5344CB8AC3E}">
        <p14:creationId xmlns:p14="http://schemas.microsoft.com/office/powerpoint/2010/main" val="22908771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88" t="25957" r="17622" b="26777"/>
          <a:stretch/>
        </p:blipFill>
        <p:spPr>
          <a:xfrm>
            <a:off x="578321" y="412273"/>
            <a:ext cx="7470124" cy="5449733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5DEA3B-801C-4EC6-DA86-88DDEFDA0AC3}"/>
              </a:ext>
            </a:extLst>
          </p:cNvPr>
          <p:cNvSpPr txBox="1"/>
          <p:nvPr/>
        </p:nvSpPr>
        <p:spPr>
          <a:xfrm>
            <a:off x="8495974" y="1062335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rest/passive thermoneutral control group 1 = exercising control group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4C2326E-2C86-E736-1180-EA6AC2CC8683}"/>
              </a:ext>
            </a:extLst>
          </p:cNvPr>
          <p:cNvSpPr txBox="1"/>
          <p:nvPr/>
        </p:nvSpPr>
        <p:spPr>
          <a:xfrm>
            <a:off x="685242" y="5935744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E</a:t>
            </a:r>
            <a:r>
              <a:rPr lang="en-GB" sz="1400" dirty="0"/>
              <a:t>. Pooled subgroup effect estimate of diastolic blood pressure to multiple-bouts of heat thermotherapy (HT) for different control group modalities. </a:t>
            </a:r>
            <a:r>
              <a:rPr lang="en-GB" sz="1400" dirty="0">
                <a:ea typeface="Aptos" panose="020B0004020202020204" pitchFamily="34" charset="0"/>
              </a:rPr>
              <a:t>Mean differences in the delta change (pre-post) between the intervention and control arms are presented in mm Hg. </a:t>
            </a:r>
            <a:endParaRPr lang="en-GB" sz="1400" dirty="0"/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C9122864-81FC-2EE6-3DFE-8F6D840C3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6</a:t>
            </a:fld>
            <a:endParaRPr lang="en-GB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B060E7B-AFEC-C4A5-FA9E-8E13ED9868B9}"/>
              </a:ext>
            </a:extLst>
          </p:cNvPr>
          <p:cNvSpPr txBox="1"/>
          <p:nvPr/>
        </p:nvSpPr>
        <p:spPr>
          <a:xfrm>
            <a:off x="4488872" y="5523452"/>
            <a:ext cx="8114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Hg</a:t>
            </a:r>
          </a:p>
        </p:txBody>
      </p:sp>
    </p:spTree>
    <p:extLst>
      <p:ext uri="{BB962C8B-B14F-4D97-AF65-F5344CB8AC3E}">
        <p14:creationId xmlns:p14="http://schemas.microsoft.com/office/powerpoint/2010/main" val="8010771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82" t="16611" r="15061" b="21594"/>
          <a:stretch/>
        </p:blipFill>
        <p:spPr>
          <a:xfrm>
            <a:off x="685242" y="183592"/>
            <a:ext cx="6305557" cy="5767830"/>
          </a:xfr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362D523-CDD9-158C-6F0B-EB11429A3B40}"/>
              </a:ext>
            </a:extLst>
          </p:cNvPr>
          <p:cNvSpPr txBox="1"/>
          <p:nvPr/>
        </p:nvSpPr>
        <p:spPr>
          <a:xfrm>
            <a:off x="7875024" y="1074846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Healthy</a:t>
            </a:r>
          </a:p>
          <a:p>
            <a:r>
              <a:rPr lang="en-GB" dirty="0"/>
              <a:t>1 = </a:t>
            </a:r>
            <a:r>
              <a:rPr lang="en-GB" b="0" i="0" dirty="0">
                <a:solidFill>
                  <a:srgbClr val="001D35"/>
                </a:solidFill>
                <a:effectLst/>
                <a:latin typeface="Google Sans"/>
              </a:rPr>
              <a:t>≥1 CVD Risk Factor</a:t>
            </a:r>
          </a:p>
          <a:p>
            <a:r>
              <a:rPr lang="en-GB" b="0" i="0" dirty="0">
                <a:solidFill>
                  <a:srgbClr val="001D35"/>
                </a:solidFill>
                <a:effectLst/>
                <a:latin typeface="Google Sans"/>
              </a:rPr>
              <a:t>2=CHF</a:t>
            </a:r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BBFA1BA-5380-00DA-21ED-DFAD5B064D9B}"/>
              </a:ext>
            </a:extLst>
          </p:cNvPr>
          <p:cNvSpPr txBox="1"/>
          <p:nvPr/>
        </p:nvSpPr>
        <p:spPr>
          <a:xfrm>
            <a:off x="685242" y="5935744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F</a:t>
            </a:r>
            <a:r>
              <a:rPr lang="en-GB" sz="1400" dirty="0"/>
              <a:t>. Pooled subgroup effect estimate of diastolic blood pressure to multiple-bouts of heat thermotherapy (HT) for different participant health statuses. </a:t>
            </a:r>
            <a:r>
              <a:rPr lang="en-GB" sz="1400" dirty="0">
                <a:ea typeface="Aptos" panose="020B0004020202020204" pitchFamily="34" charset="0"/>
              </a:rPr>
              <a:t>Mean differences in the delta change (pre-post) between the intervention and control arms are presented in mm Hg. 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E5ECFE74-9CD5-9541-3DA6-EF7CACAA0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7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3102979-0D5B-ED49-4BFF-C4DE907F9701}"/>
              </a:ext>
            </a:extLst>
          </p:cNvPr>
          <p:cNvSpPr txBox="1"/>
          <p:nvPr/>
        </p:nvSpPr>
        <p:spPr>
          <a:xfrm>
            <a:off x="3748645" y="5550123"/>
            <a:ext cx="8114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Hg</a:t>
            </a:r>
          </a:p>
        </p:txBody>
      </p:sp>
    </p:spTree>
    <p:extLst>
      <p:ext uri="{BB962C8B-B14F-4D97-AF65-F5344CB8AC3E}">
        <p14:creationId xmlns:p14="http://schemas.microsoft.com/office/powerpoint/2010/main" val="21680957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065" b="30431"/>
          <a:stretch/>
        </p:blipFill>
        <p:spPr>
          <a:xfrm>
            <a:off x="290531" y="1214924"/>
            <a:ext cx="11248630" cy="3993850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3CAB7D8-64C5-CF34-BB6C-15693D326DA9}"/>
              </a:ext>
            </a:extLst>
          </p:cNvPr>
          <p:cNvSpPr txBox="1"/>
          <p:nvPr/>
        </p:nvSpPr>
        <p:spPr>
          <a:xfrm>
            <a:off x="783182" y="5381301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G</a:t>
            </a:r>
            <a:r>
              <a:rPr lang="en-GB" sz="1400" dirty="0"/>
              <a:t>. Pooled effect estimate of the flow-mediated dilation response to multiple-bouts of heat thermotherapy (HT) after publication outliers were removed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DEA66A-BF49-5CB0-09E6-F43B69945E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8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97B2A83-9D14-B3B7-3CB0-453E01F42962}"/>
              </a:ext>
            </a:extLst>
          </p:cNvPr>
          <p:cNvSpPr txBox="1"/>
          <p:nvPr/>
        </p:nvSpPr>
        <p:spPr>
          <a:xfrm>
            <a:off x="9278585" y="4870220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22762530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07327A7-857E-E62B-FDF2-EC76549AD20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71" t="26060" r="17279" b="25983"/>
          <a:stretch/>
        </p:blipFill>
        <p:spPr>
          <a:xfrm>
            <a:off x="590526" y="312868"/>
            <a:ext cx="7321675" cy="5381301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5DEA3B-801C-4EC6-DA86-88DDEFDA0AC3}"/>
              </a:ext>
            </a:extLst>
          </p:cNvPr>
          <p:cNvSpPr txBox="1"/>
          <p:nvPr/>
        </p:nvSpPr>
        <p:spPr>
          <a:xfrm>
            <a:off x="8426962" y="1286622"/>
            <a:ext cx="30479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0 = rest/passive thermoneutral control group 1 = exercising control group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7A1ED97-35E3-1CE6-021C-6A38958E1842}"/>
              </a:ext>
            </a:extLst>
          </p:cNvPr>
          <p:cNvSpPr txBox="1"/>
          <p:nvPr/>
        </p:nvSpPr>
        <p:spPr>
          <a:xfrm>
            <a:off x="783182" y="5864381"/>
            <a:ext cx="100170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/>
              <a:t>Supplementary 2H</a:t>
            </a:r>
            <a:r>
              <a:rPr lang="en-GB" sz="1400" dirty="0"/>
              <a:t>. Pooled effect estimate of the flow-mediated dilation response to multiple-bouts of heat thermotherapy (HT) for different control groups. </a:t>
            </a:r>
            <a:r>
              <a:rPr lang="en-GB" sz="1400" dirty="0">
                <a:latin typeface="Aptos" panose="020B0004020202020204" pitchFamily="34" charset="0"/>
                <a:ea typeface="Aptos" panose="020B0004020202020204" pitchFamily="34" charset="0"/>
              </a:rPr>
              <a:t>Standardised mean differences in the delta change (pre-post) between the intervention and control arms are presented as an effect size (Hedges’ g).</a:t>
            </a:r>
            <a:endParaRPr lang="en-GB" sz="1400" dirty="0"/>
          </a:p>
        </p:txBody>
      </p:sp>
      <p:sp>
        <p:nvSpPr>
          <p:cNvPr id="8" name="Slide Number Placeholder 7">
            <a:extLst>
              <a:ext uri="{FF2B5EF4-FFF2-40B4-BE49-F238E27FC236}">
                <a16:creationId xmlns:a16="http://schemas.microsoft.com/office/drawing/2014/main" id="{953ABA44-FAC3-E6F8-2753-35B5A83D2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EF786-D0A4-4F25-B00E-C4472C9218D9}" type="slidenum">
              <a:rPr lang="en-GB" smtClean="0"/>
              <a:t>9</a:t>
            </a:fld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094CD7A-1060-808F-3039-C5BEA063A4C9}"/>
              </a:ext>
            </a:extLst>
          </p:cNvPr>
          <p:cNvSpPr txBox="1"/>
          <p:nvPr/>
        </p:nvSpPr>
        <p:spPr>
          <a:xfrm>
            <a:off x="4437412" y="5406462"/>
            <a:ext cx="11796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dges’ g</a:t>
            </a:r>
          </a:p>
        </p:txBody>
      </p:sp>
    </p:spTree>
    <p:extLst>
      <p:ext uri="{BB962C8B-B14F-4D97-AF65-F5344CB8AC3E}">
        <p14:creationId xmlns:p14="http://schemas.microsoft.com/office/powerpoint/2010/main" val="373843307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e2c4f51b-0c42-4208-b54d-06a3191e4db0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5</TotalTime>
  <Words>1734</Words>
  <Application>Microsoft Office PowerPoint</Application>
  <PresentationFormat>Widescreen</PresentationFormat>
  <Paragraphs>125</Paragraphs>
  <Slides>2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9</vt:i4>
      </vt:variant>
    </vt:vector>
  </HeadingPairs>
  <TitlesOfParts>
    <vt:vector size="35" baseType="lpstr">
      <vt:lpstr>Aptos</vt:lpstr>
      <vt:lpstr>Aptos Display</vt:lpstr>
      <vt:lpstr>Arial</vt:lpstr>
      <vt:lpstr>Calibri</vt:lpstr>
      <vt:lpstr>Google Sans</vt:lpstr>
      <vt:lpstr>Office Theme</vt:lpstr>
      <vt:lpstr>Supplementary II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n Price</dc:creator>
  <cp:lastModifiedBy>Ben Price</cp:lastModifiedBy>
  <cp:revision>1</cp:revision>
  <dcterms:created xsi:type="dcterms:W3CDTF">2025-06-16T13:39:39Z</dcterms:created>
  <dcterms:modified xsi:type="dcterms:W3CDTF">2025-09-29T15:31:45Z</dcterms:modified>
</cp:coreProperties>
</file>